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369" r:id="rId2"/>
    <p:sldId id="368" r:id="rId3"/>
    <p:sldId id="347" r:id="rId4"/>
    <p:sldId id="34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F8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74"/>
    <p:restoredTop sz="88768" autoAdjust="0"/>
  </p:normalViewPr>
  <p:slideViewPr>
    <p:cSldViewPr snapToGrid="0">
      <p:cViewPr varScale="1">
        <p:scale>
          <a:sx n="68" d="100"/>
          <a:sy n="68" d="100"/>
        </p:scale>
        <p:origin x="870" y="72"/>
      </p:cViewPr>
      <p:guideLst>
        <p:guide orient="horz" pos="2160"/>
        <p:guide pos="38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5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由美子 秋田" userId="982681295766d2be" providerId="LiveId" clId="{3080C51B-A172-4BCD-97F8-872BA5E85E07}"/>
    <pc:docChg chg="undo custSel addSld modSld">
      <pc:chgData name="由美子 秋田" userId="982681295766d2be" providerId="LiveId" clId="{3080C51B-A172-4BCD-97F8-872BA5E85E07}" dt="2025-02-25T07:40:39.808" v="527" actId="20577"/>
      <pc:docMkLst>
        <pc:docMk/>
      </pc:docMkLst>
      <pc:sldChg chg="modSp mod modNotesTx">
        <pc:chgData name="由美子 秋田" userId="982681295766d2be" providerId="LiveId" clId="{3080C51B-A172-4BCD-97F8-872BA5E85E07}" dt="2025-02-25T07:40:39.808" v="527" actId="20577"/>
        <pc:sldMkLst>
          <pc:docMk/>
          <pc:sldMk cId="275719505" sldId="261"/>
        </pc:sldMkLst>
        <pc:spChg chg="mod">
          <ac:chgData name="由美子 秋田" userId="982681295766d2be" providerId="LiveId" clId="{3080C51B-A172-4BCD-97F8-872BA5E85E07}" dt="2025-02-24T08:25:32.592" v="506" actId="20577"/>
          <ac:spMkLst>
            <pc:docMk/>
            <pc:sldMk cId="275719505" sldId="261"/>
            <ac:spMk id="2" creationId="{BCC52EB3-5550-5C9B-B3F5-C721714BB495}"/>
          </ac:spMkLst>
        </pc:spChg>
      </pc:sldChg>
      <pc:sldChg chg="modSp mod">
        <pc:chgData name="由美子 秋田" userId="982681295766d2be" providerId="LiveId" clId="{3080C51B-A172-4BCD-97F8-872BA5E85E07}" dt="2025-02-04T04:50:47.371" v="397" actId="20577"/>
        <pc:sldMkLst>
          <pc:docMk/>
          <pc:sldMk cId="910199644" sldId="262"/>
        </pc:sldMkLst>
        <pc:spChg chg="mod">
          <ac:chgData name="由美子 秋田" userId="982681295766d2be" providerId="LiveId" clId="{3080C51B-A172-4BCD-97F8-872BA5E85E07}" dt="2025-02-04T04:48:56.931" v="392" actId="20577"/>
          <ac:spMkLst>
            <pc:docMk/>
            <pc:sldMk cId="910199644" sldId="262"/>
            <ac:spMk id="4" creationId="{43FF1997-6697-1A55-4920-70C011F4DAFC}"/>
          </ac:spMkLst>
        </pc:spChg>
        <pc:spChg chg="mod">
          <ac:chgData name="由美子 秋田" userId="982681295766d2be" providerId="LiveId" clId="{3080C51B-A172-4BCD-97F8-872BA5E85E07}" dt="2025-02-04T04:50:47.371" v="397" actId="20577"/>
          <ac:spMkLst>
            <pc:docMk/>
            <pc:sldMk cId="910199644" sldId="262"/>
            <ac:spMk id="209" creationId="{20EB5611-49F3-3B5B-820D-AFA9E283615F}"/>
          </ac:spMkLst>
        </pc:spChg>
      </pc:sldChg>
      <pc:sldChg chg="modSp mod">
        <pc:chgData name="由美子 秋田" userId="982681295766d2be" providerId="LiveId" clId="{3080C51B-A172-4BCD-97F8-872BA5E85E07}" dt="2025-02-04T04:43:00.258" v="381" actId="20577"/>
        <pc:sldMkLst>
          <pc:docMk/>
          <pc:sldMk cId="1041882890" sldId="268"/>
        </pc:sldMkLst>
        <pc:spChg chg="mod">
          <ac:chgData name="由美子 秋田" userId="982681295766d2be" providerId="LiveId" clId="{3080C51B-A172-4BCD-97F8-872BA5E85E07}" dt="2025-02-04T04:43:00.258" v="381" actId="20577"/>
          <ac:spMkLst>
            <pc:docMk/>
            <pc:sldMk cId="1041882890" sldId="268"/>
            <ac:spMk id="6" creationId="{0E68BE50-2496-2FBB-BD97-8DB644B5FB9D}"/>
          </ac:spMkLst>
        </pc:spChg>
      </pc:sldChg>
      <pc:sldChg chg="modSp mod">
        <pc:chgData name="由美子 秋田" userId="982681295766d2be" providerId="LiveId" clId="{3080C51B-A172-4BCD-97F8-872BA5E85E07}" dt="2025-02-24T08:26:55.944" v="517" actId="313"/>
        <pc:sldMkLst>
          <pc:docMk/>
          <pc:sldMk cId="1634665014" sldId="301"/>
        </pc:sldMkLst>
        <pc:spChg chg="mod">
          <ac:chgData name="由美子 秋田" userId="982681295766d2be" providerId="LiveId" clId="{3080C51B-A172-4BCD-97F8-872BA5E85E07}" dt="2025-02-24T08:26:55.944" v="517" actId="313"/>
          <ac:spMkLst>
            <pc:docMk/>
            <pc:sldMk cId="1634665014" sldId="301"/>
            <ac:spMk id="10" creationId="{50993A8F-E432-AA4D-A9D7-7CD9395D9E92}"/>
          </ac:spMkLst>
        </pc:spChg>
      </pc:sldChg>
      <pc:sldChg chg="modSp mod">
        <pc:chgData name="由美子 秋田" userId="982681295766d2be" providerId="LiveId" clId="{3080C51B-A172-4BCD-97F8-872BA5E85E07}" dt="2025-02-04T04:52:36.341" v="408" actId="20577"/>
        <pc:sldMkLst>
          <pc:docMk/>
          <pc:sldMk cId="4164275393" sldId="312"/>
        </pc:sldMkLst>
        <pc:spChg chg="mod">
          <ac:chgData name="由美子 秋田" userId="982681295766d2be" providerId="LiveId" clId="{3080C51B-A172-4BCD-97F8-872BA5E85E07}" dt="2025-02-04T04:52:36.341" v="408" actId="20577"/>
          <ac:spMkLst>
            <pc:docMk/>
            <pc:sldMk cId="4164275393" sldId="312"/>
            <ac:spMk id="6" creationId="{0B4582FB-8614-E60E-590A-144D6BEA8CBF}"/>
          </ac:spMkLst>
        </pc:spChg>
        <pc:spChg chg="mod">
          <ac:chgData name="由美子 秋田" userId="982681295766d2be" providerId="LiveId" clId="{3080C51B-A172-4BCD-97F8-872BA5E85E07}" dt="2025-02-04T04:48:47.617" v="386" actId="20577"/>
          <ac:spMkLst>
            <pc:docMk/>
            <pc:sldMk cId="4164275393" sldId="312"/>
            <ac:spMk id="8" creationId="{62CC3B2F-C912-AE92-7A2D-73AF38DAC535}"/>
          </ac:spMkLst>
        </pc:spChg>
      </pc:sldChg>
      <pc:sldChg chg="modSp mod">
        <pc:chgData name="由美子 秋田" userId="982681295766d2be" providerId="LiveId" clId="{3080C51B-A172-4BCD-97F8-872BA5E85E07}" dt="2025-02-04T04:52:54.449" v="409" actId="20577"/>
        <pc:sldMkLst>
          <pc:docMk/>
          <pc:sldMk cId="3204364479" sldId="313"/>
        </pc:sldMkLst>
        <pc:spChg chg="mod">
          <ac:chgData name="由美子 秋田" userId="982681295766d2be" providerId="LiveId" clId="{3080C51B-A172-4BCD-97F8-872BA5E85E07}" dt="2025-02-04T04:48:33.947" v="383" actId="20577"/>
          <ac:spMkLst>
            <pc:docMk/>
            <pc:sldMk cId="3204364479" sldId="313"/>
            <ac:spMk id="6" creationId="{95139C89-2F6D-1AEA-F707-4DFB09C618A1}"/>
          </ac:spMkLst>
        </pc:spChg>
        <pc:spChg chg="mod">
          <ac:chgData name="由美子 秋田" userId="982681295766d2be" providerId="LiveId" clId="{3080C51B-A172-4BCD-97F8-872BA5E85E07}" dt="2025-02-04T04:52:54.449" v="409" actId="20577"/>
          <ac:spMkLst>
            <pc:docMk/>
            <pc:sldMk cId="3204364479" sldId="313"/>
            <ac:spMk id="141" creationId="{F5E0EE28-521D-C10B-7FEE-26237BFBF4B8}"/>
          </ac:spMkLst>
        </pc:spChg>
      </pc:sldChg>
      <pc:sldChg chg="modSp mod">
        <pc:chgData name="由美子 秋田" userId="982681295766d2be" providerId="LiveId" clId="{3080C51B-A172-4BCD-97F8-872BA5E85E07}" dt="2025-02-04T04:53:43.497" v="427" actId="20577"/>
        <pc:sldMkLst>
          <pc:docMk/>
          <pc:sldMk cId="1674619836" sldId="314"/>
        </pc:sldMkLst>
        <pc:spChg chg="mod">
          <ac:chgData name="由美子 秋田" userId="982681295766d2be" providerId="LiveId" clId="{3080C51B-A172-4BCD-97F8-872BA5E85E07}" dt="2025-02-04T04:42:41.836" v="372" actId="20577"/>
          <ac:spMkLst>
            <pc:docMk/>
            <pc:sldMk cId="1674619836" sldId="314"/>
            <ac:spMk id="129" creationId="{10F1B7FD-7038-5555-6CEF-3C96CC421907}"/>
          </ac:spMkLst>
        </pc:spChg>
        <pc:spChg chg="mod">
          <ac:chgData name="由美子 秋田" userId="982681295766d2be" providerId="LiveId" clId="{3080C51B-A172-4BCD-97F8-872BA5E85E07}" dt="2025-02-04T04:53:43.497" v="427" actId="20577"/>
          <ac:spMkLst>
            <pc:docMk/>
            <pc:sldMk cId="1674619836" sldId="314"/>
            <ac:spMk id="130" creationId="{E1792C60-5213-3E38-A0D5-5129F069B47C}"/>
          </ac:spMkLst>
        </pc:spChg>
        <pc:spChg chg="mod">
          <ac:chgData name="由美子 秋田" userId="982681295766d2be" providerId="LiveId" clId="{3080C51B-A172-4BCD-97F8-872BA5E85E07}" dt="2025-02-04T04:42:49.209" v="380" actId="20577"/>
          <ac:spMkLst>
            <pc:docMk/>
            <pc:sldMk cId="1674619836" sldId="314"/>
            <ac:spMk id="328" creationId="{B86E3AAC-35CF-57EA-69B1-9922CD47BA81}"/>
          </ac:spMkLst>
        </pc:spChg>
      </pc:sldChg>
      <pc:sldChg chg="modSp mod">
        <pc:chgData name="由美子 秋田" userId="982681295766d2be" providerId="LiveId" clId="{3080C51B-A172-4BCD-97F8-872BA5E85E07}" dt="2025-02-24T08:23:54.084" v="470" actId="20577"/>
        <pc:sldMkLst>
          <pc:docMk/>
          <pc:sldMk cId="675113385" sldId="321"/>
        </pc:sldMkLst>
        <pc:spChg chg="mod">
          <ac:chgData name="由美子 秋田" userId="982681295766d2be" providerId="LiveId" clId="{3080C51B-A172-4BCD-97F8-872BA5E85E07}" dt="2025-02-24T08:23:54.084" v="470" actId="20577"/>
          <ac:spMkLst>
            <pc:docMk/>
            <pc:sldMk cId="675113385" sldId="321"/>
            <ac:spMk id="14" creationId="{DFA435CC-AEEC-35B0-6F23-9A617C7B5FE8}"/>
          </ac:spMkLst>
        </pc:spChg>
      </pc:sldChg>
      <pc:sldChg chg="modSp mod">
        <pc:chgData name="由美子 秋田" userId="982681295766d2be" providerId="LiveId" clId="{3080C51B-A172-4BCD-97F8-872BA5E85E07}" dt="2025-02-24T08:26:55.334" v="516" actId="313"/>
        <pc:sldMkLst>
          <pc:docMk/>
          <pc:sldMk cId="3912212708" sldId="340"/>
        </pc:sldMkLst>
        <pc:spChg chg="mod">
          <ac:chgData name="由美子 秋田" userId="982681295766d2be" providerId="LiveId" clId="{3080C51B-A172-4BCD-97F8-872BA5E85E07}" dt="2025-02-24T08:26:55.334" v="516" actId="313"/>
          <ac:spMkLst>
            <pc:docMk/>
            <pc:sldMk cId="3912212708" sldId="340"/>
            <ac:spMk id="2" creationId="{45A4AA59-BA59-6A61-6296-255D9630AFE2}"/>
          </ac:spMkLst>
        </pc:spChg>
      </pc:sldChg>
      <pc:sldChg chg="modSp mod modNotesTx">
        <pc:chgData name="由美子 秋田" userId="982681295766d2be" providerId="LiveId" clId="{3080C51B-A172-4BCD-97F8-872BA5E85E07}" dt="2025-02-24T08:26:52.891" v="512" actId="313"/>
        <pc:sldMkLst>
          <pc:docMk/>
          <pc:sldMk cId="729325973" sldId="343"/>
        </pc:sldMkLst>
        <pc:spChg chg="mod">
          <ac:chgData name="由美子 秋田" userId="982681295766d2be" providerId="LiveId" clId="{3080C51B-A172-4BCD-97F8-872BA5E85E07}" dt="2025-02-24T08:26:52.891" v="512" actId="313"/>
          <ac:spMkLst>
            <pc:docMk/>
            <pc:sldMk cId="729325973" sldId="343"/>
            <ac:spMk id="3" creationId="{D817F767-4767-938D-5DB2-08D9AB816025}"/>
          </ac:spMkLst>
        </pc:spChg>
      </pc:sldChg>
      <pc:sldChg chg="modSp mod">
        <pc:chgData name="由美子 秋田" userId="982681295766d2be" providerId="LiveId" clId="{3080C51B-A172-4BCD-97F8-872BA5E85E07}" dt="2025-02-24T08:26:56.642" v="518" actId="313"/>
        <pc:sldMkLst>
          <pc:docMk/>
          <pc:sldMk cId="1318259939" sldId="346"/>
        </pc:sldMkLst>
        <pc:spChg chg="mod">
          <ac:chgData name="由美子 秋田" userId="982681295766d2be" providerId="LiveId" clId="{3080C51B-A172-4BCD-97F8-872BA5E85E07}" dt="2025-02-24T08:26:56.642" v="518" actId="313"/>
          <ac:spMkLst>
            <pc:docMk/>
            <pc:sldMk cId="1318259939" sldId="346"/>
            <ac:spMk id="3" creationId="{C50D48F5-19FD-2DE9-7735-FDE811BAD3BE}"/>
          </ac:spMkLst>
        </pc:spChg>
      </pc:sldChg>
      <pc:sldChg chg="modSp mod">
        <pc:chgData name="由美子 秋田" userId="982681295766d2be" providerId="LiveId" clId="{3080C51B-A172-4BCD-97F8-872BA5E85E07}" dt="2025-02-24T08:25:08.209" v="505" actId="20577"/>
        <pc:sldMkLst>
          <pc:docMk/>
          <pc:sldMk cId="155270153" sldId="347"/>
        </pc:sldMkLst>
        <pc:spChg chg="mod">
          <ac:chgData name="由美子 秋田" userId="982681295766d2be" providerId="LiveId" clId="{3080C51B-A172-4BCD-97F8-872BA5E85E07}" dt="2025-02-24T08:25:08.209" v="505" actId="20577"/>
          <ac:spMkLst>
            <pc:docMk/>
            <pc:sldMk cId="155270153" sldId="347"/>
            <ac:spMk id="2" creationId="{4F8E0D62-881E-BDFE-7790-3DB67539FB71}"/>
          </ac:spMkLst>
        </pc:spChg>
        <pc:spChg chg="mod">
          <ac:chgData name="由美子 秋田" userId="982681295766d2be" providerId="LiveId" clId="{3080C51B-A172-4BCD-97F8-872BA5E85E07}" dt="2025-02-24T06:46:51.796" v="441" actId="20577"/>
          <ac:spMkLst>
            <pc:docMk/>
            <pc:sldMk cId="155270153" sldId="347"/>
            <ac:spMk id="3" creationId="{98B3F4B0-6D84-3C3C-0F2B-000E690DECFF}"/>
          </ac:spMkLst>
        </pc:spChg>
      </pc:sldChg>
      <pc:sldChg chg="modSp mod">
        <pc:chgData name="由美子 秋田" userId="982681295766d2be" providerId="LiveId" clId="{3080C51B-A172-4BCD-97F8-872BA5E85E07}" dt="2025-02-04T04:26:07.380" v="154" actId="20577"/>
        <pc:sldMkLst>
          <pc:docMk/>
          <pc:sldMk cId="3971416951" sldId="362"/>
        </pc:sldMkLst>
        <pc:spChg chg="mod">
          <ac:chgData name="由美子 秋田" userId="982681295766d2be" providerId="LiveId" clId="{3080C51B-A172-4BCD-97F8-872BA5E85E07}" dt="2025-02-04T04:26:07.380" v="154" actId="20577"/>
          <ac:spMkLst>
            <pc:docMk/>
            <pc:sldMk cId="3971416951" sldId="362"/>
            <ac:spMk id="3" creationId="{1CFD4F94-C555-D9FA-A7CF-1E9C10E096C4}"/>
          </ac:spMkLst>
        </pc:spChg>
      </pc:sldChg>
      <pc:sldChg chg="addSp delSp modSp mod">
        <pc:chgData name="由美子 秋田" userId="982681295766d2be" providerId="LiveId" clId="{3080C51B-A172-4BCD-97F8-872BA5E85E07}" dt="2025-02-25T05:12:08.602" v="526" actId="21"/>
        <pc:sldMkLst>
          <pc:docMk/>
          <pc:sldMk cId="3442016219" sldId="363"/>
        </pc:sldMkLst>
        <pc:spChg chg="mod">
          <ac:chgData name="由美子 秋田" userId="982681295766d2be" providerId="LiveId" clId="{3080C51B-A172-4BCD-97F8-872BA5E85E07}" dt="2025-02-04T04:32:38.131" v="323" actId="20577"/>
          <ac:spMkLst>
            <pc:docMk/>
            <pc:sldMk cId="3442016219" sldId="363"/>
            <ac:spMk id="9" creationId="{ED67790F-2FF6-7FE2-A2AA-6ED20E903C96}"/>
          </ac:spMkLst>
        </pc:spChg>
        <pc:picChg chg="add del mod">
          <ac:chgData name="由美子 秋田" userId="982681295766d2be" providerId="LiveId" clId="{3080C51B-A172-4BCD-97F8-872BA5E85E07}" dt="2025-02-25T05:12:08.602" v="526" actId="21"/>
          <ac:picMkLst>
            <pc:docMk/>
            <pc:sldMk cId="3442016219" sldId="363"/>
            <ac:picMk id="3" creationId="{177E8B2B-8C80-F88D-03D7-4DDDDF9251AA}"/>
          </ac:picMkLst>
        </pc:picChg>
      </pc:sldChg>
      <pc:sldChg chg="modSp mod">
        <pc:chgData name="由美子 秋田" userId="982681295766d2be" providerId="LiveId" clId="{3080C51B-A172-4BCD-97F8-872BA5E85E07}" dt="2025-02-04T04:41:03.878" v="353" actId="20577"/>
        <pc:sldMkLst>
          <pc:docMk/>
          <pc:sldMk cId="2378794941" sldId="367"/>
        </pc:sldMkLst>
        <pc:spChg chg="mod">
          <ac:chgData name="由美子 秋田" userId="982681295766d2be" providerId="LiveId" clId="{3080C51B-A172-4BCD-97F8-872BA5E85E07}" dt="2025-02-04T04:41:03.878" v="353" actId="20577"/>
          <ac:spMkLst>
            <pc:docMk/>
            <pc:sldMk cId="2378794941" sldId="367"/>
            <ac:spMk id="3" creationId="{F2253EED-71B3-14EA-6A6A-166D53C249BA}"/>
          </ac:spMkLst>
        </pc:spChg>
      </pc:sldChg>
      <pc:sldChg chg="modSp mod">
        <pc:chgData name="由美子 秋田" userId="982681295766d2be" providerId="LiveId" clId="{3080C51B-A172-4BCD-97F8-872BA5E85E07}" dt="2025-02-24T06:47:10.486" v="449" actId="20577"/>
        <pc:sldMkLst>
          <pc:docMk/>
          <pc:sldMk cId="1066298654" sldId="368"/>
        </pc:sldMkLst>
        <pc:spChg chg="mod">
          <ac:chgData name="由美子 秋田" userId="982681295766d2be" providerId="LiveId" clId="{3080C51B-A172-4BCD-97F8-872BA5E85E07}" dt="2025-02-24T06:46:46.109" v="437" actId="20577"/>
          <ac:spMkLst>
            <pc:docMk/>
            <pc:sldMk cId="1066298654" sldId="368"/>
            <ac:spMk id="4" creationId="{89A0FF72-456E-69A8-085B-E683612AEE14}"/>
          </ac:spMkLst>
        </pc:spChg>
        <pc:spChg chg="mod">
          <ac:chgData name="由美子 秋田" userId="982681295766d2be" providerId="LiveId" clId="{3080C51B-A172-4BCD-97F8-872BA5E85E07}" dt="2025-02-24T06:47:10.486" v="449" actId="20577"/>
          <ac:spMkLst>
            <pc:docMk/>
            <pc:sldMk cId="1066298654" sldId="368"/>
            <ac:spMk id="8" creationId="{C19B9AD4-EA35-AE1E-6BC7-ED7FB284558B}"/>
          </ac:spMkLst>
        </pc:spChg>
      </pc:sldChg>
      <pc:sldChg chg="addSp delSp modSp new mod">
        <pc:chgData name="由美子 秋田" userId="982681295766d2be" providerId="LiveId" clId="{3080C51B-A172-4BCD-97F8-872BA5E85E07}" dt="2025-02-24T06:50:36.939" v="469" actId="20577"/>
        <pc:sldMkLst>
          <pc:docMk/>
          <pc:sldMk cId="3208574252" sldId="369"/>
        </pc:sldMkLst>
        <pc:spChg chg="del">
          <ac:chgData name="由美子 秋田" userId="982681295766d2be" providerId="LiveId" clId="{3080C51B-A172-4BCD-97F8-872BA5E85E07}" dt="2025-02-24T06:46:25.848" v="430" actId="478"/>
          <ac:spMkLst>
            <pc:docMk/>
            <pc:sldMk cId="3208574252" sldId="369"/>
            <ac:spMk id="2" creationId="{61A150E7-B413-F183-D8C9-CE7D86A2C450}"/>
          </ac:spMkLst>
        </pc:spChg>
        <pc:spChg chg="add mod">
          <ac:chgData name="由美子 秋田" userId="982681295766d2be" providerId="LiveId" clId="{3080C51B-A172-4BCD-97F8-872BA5E85E07}" dt="2025-02-24T06:46:34.286" v="431"/>
          <ac:spMkLst>
            <pc:docMk/>
            <pc:sldMk cId="3208574252" sldId="369"/>
            <ac:spMk id="4" creationId="{B7E120EC-CACF-CF6A-CCDA-2FA84B475F6E}"/>
          </ac:spMkLst>
        </pc:spChg>
        <pc:spChg chg="add mod">
          <ac:chgData name="由美子 秋田" userId="982681295766d2be" providerId="LiveId" clId="{3080C51B-A172-4BCD-97F8-872BA5E85E07}" dt="2025-02-24T06:50:36.939" v="469" actId="20577"/>
          <ac:spMkLst>
            <pc:docMk/>
            <pc:sldMk cId="3208574252" sldId="369"/>
            <ac:spMk id="5" creationId="{E14517FC-5D09-F4D7-BD30-60E0209BDDFF}"/>
          </ac:spMkLst>
        </pc:spChg>
        <pc:picChg chg="add mod">
          <ac:chgData name="由美子 秋田" userId="982681295766d2be" providerId="LiveId" clId="{3080C51B-A172-4BCD-97F8-872BA5E85E07}" dt="2025-02-24T06:47:17.083" v="451" actId="1076"/>
          <ac:picMkLst>
            <pc:docMk/>
            <pc:sldMk cId="3208574252" sldId="369"/>
            <ac:picMk id="3" creationId="{E1C57E3E-2C35-950F-91BE-EC3870EAC5C7}"/>
          </ac:picMkLst>
        </pc:picChg>
      </pc:sldChg>
    </pc:docChg>
  </pc:docChgLst>
  <pc:docChgLst>
    <pc:chgData name="由美子 秋田" userId="982681295766d2be" providerId="LiveId" clId="{CAB8CD0B-5920-45D8-B34E-245C102B7905}"/>
    <pc:docChg chg="modSld">
      <pc:chgData name="由美子 秋田" userId="982681295766d2be" providerId="LiveId" clId="{CAB8CD0B-5920-45D8-B34E-245C102B7905}" dt="2025-02-04T01:48:22.628" v="8" actId="165"/>
      <pc:docMkLst>
        <pc:docMk/>
      </pc:docMkLst>
      <pc:sldChg chg="delSp modSp mod">
        <pc:chgData name="由美子 秋田" userId="982681295766d2be" providerId="LiveId" clId="{CAB8CD0B-5920-45D8-B34E-245C102B7905}" dt="2025-02-04T01:48:22.628" v="8" actId="165"/>
        <pc:sldMkLst>
          <pc:docMk/>
          <pc:sldMk cId="3442016219" sldId="363"/>
        </pc:sldMkLst>
        <pc:spChg chg="mod topLvl">
          <ac:chgData name="由美子 秋田" userId="982681295766d2be" providerId="LiveId" clId="{CAB8CD0B-5920-45D8-B34E-245C102B7905}" dt="2025-02-04T01:48:22.628" v="8" actId="165"/>
          <ac:spMkLst>
            <pc:docMk/>
            <pc:sldMk cId="3442016219" sldId="363"/>
            <ac:spMk id="5" creationId="{C9433C1B-3FA5-0E22-CD36-A2AD5514B6BB}"/>
          </ac:spMkLst>
        </pc:spChg>
        <pc:spChg chg="mod topLvl">
          <ac:chgData name="由美子 秋田" userId="982681295766d2be" providerId="LiveId" clId="{CAB8CD0B-5920-45D8-B34E-245C102B7905}" dt="2025-02-04T01:48:22.628" v="8" actId="165"/>
          <ac:spMkLst>
            <pc:docMk/>
            <pc:sldMk cId="3442016219" sldId="363"/>
            <ac:spMk id="6" creationId="{7E67A5E9-DB6E-C8FB-F6E8-8BD3D1F8F4EE}"/>
          </ac:spMkLst>
        </pc:spChg>
        <pc:spChg chg="mod topLvl">
          <ac:chgData name="由美子 秋田" userId="982681295766d2be" providerId="LiveId" clId="{CAB8CD0B-5920-45D8-B34E-245C102B7905}" dt="2025-02-04T01:48:22.628" v="8" actId="165"/>
          <ac:spMkLst>
            <pc:docMk/>
            <pc:sldMk cId="3442016219" sldId="363"/>
            <ac:spMk id="7" creationId="{5EB52D49-9CFF-79BF-1CFD-329B03356AA7}"/>
          </ac:spMkLst>
        </pc:spChg>
        <pc:spChg chg="mod">
          <ac:chgData name="由美子 秋田" userId="982681295766d2be" providerId="LiveId" clId="{CAB8CD0B-5920-45D8-B34E-245C102B7905}" dt="2025-02-04T01:46:43.362" v="7" actId="20577"/>
          <ac:spMkLst>
            <pc:docMk/>
            <pc:sldMk cId="3442016219" sldId="363"/>
            <ac:spMk id="9" creationId="{ED67790F-2FF6-7FE2-A2AA-6ED20E903C96}"/>
          </ac:spMkLst>
        </pc:spChg>
        <pc:picChg chg="mod topLvl">
          <ac:chgData name="由美子 秋田" userId="982681295766d2be" providerId="LiveId" clId="{CAB8CD0B-5920-45D8-B34E-245C102B7905}" dt="2025-02-04T01:48:22.628" v="8" actId="165"/>
          <ac:picMkLst>
            <pc:docMk/>
            <pc:sldMk cId="3442016219" sldId="363"/>
            <ac:picMk id="4" creationId="{CE458876-B28A-707D-E315-A9E59AA2F1C6}"/>
          </ac:picMkLst>
        </pc:picChg>
      </pc:sldChg>
    </pc:docChg>
  </pc:docChgLst>
  <pc:docChgLst>
    <pc:chgData name="由美子 秋田" userId="982681295766d2be" providerId="LiveId" clId="{81DC723C-AF0E-4E57-9BD4-9DF701AD38B1}"/>
    <pc:docChg chg="undo custSel modSld">
      <pc:chgData name="由美子 秋田" userId="982681295766d2be" providerId="LiveId" clId="{81DC723C-AF0E-4E57-9BD4-9DF701AD38B1}" dt="2024-12-03T06:44:49.740" v="229" actId="255"/>
      <pc:docMkLst>
        <pc:docMk/>
      </pc:docMkLst>
      <pc:sldChg chg="modSp mod">
        <pc:chgData name="由美子 秋田" userId="982681295766d2be" providerId="LiveId" clId="{81DC723C-AF0E-4E57-9BD4-9DF701AD38B1}" dt="2024-12-03T05:58:22.922" v="205" actId="2711"/>
        <pc:sldMkLst>
          <pc:docMk/>
          <pc:sldMk cId="275719505" sldId="261"/>
        </pc:sldMkLst>
        <pc:spChg chg="mod">
          <ac:chgData name="由美子 秋田" userId="982681295766d2be" providerId="LiveId" clId="{81DC723C-AF0E-4E57-9BD4-9DF701AD38B1}" dt="2024-12-03T04:13:28.052" v="75" actId="113"/>
          <ac:spMkLst>
            <pc:docMk/>
            <pc:sldMk cId="275719505" sldId="261"/>
            <ac:spMk id="2" creationId="{BCC52EB3-5550-5C9B-B3F5-C721714BB495}"/>
          </ac:spMkLst>
        </pc:spChg>
        <pc:spChg chg="mod">
          <ac:chgData name="由美子 秋田" userId="982681295766d2be" providerId="LiveId" clId="{81DC723C-AF0E-4E57-9BD4-9DF701AD38B1}" dt="2024-12-03T05:58:22.922" v="205" actId="2711"/>
          <ac:spMkLst>
            <pc:docMk/>
            <pc:sldMk cId="275719505" sldId="261"/>
            <ac:spMk id="4" creationId="{6A363A19-3788-5AD0-FD0F-973681EC0506}"/>
          </ac:spMkLst>
        </pc:spChg>
        <pc:spChg chg="mod">
          <ac:chgData name="由美子 秋田" userId="982681295766d2be" providerId="LiveId" clId="{81DC723C-AF0E-4E57-9BD4-9DF701AD38B1}" dt="2024-12-03T05:48:42.739" v="154" actId="2711"/>
          <ac:spMkLst>
            <pc:docMk/>
            <pc:sldMk cId="275719505" sldId="261"/>
            <ac:spMk id="6" creationId="{8FE6ADD1-FAA0-D492-E43A-A78185D77F88}"/>
          </ac:spMkLst>
        </pc:spChg>
      </pc:sldChg>
      <pc:sldChg chg="modSp mod">
        <pc:chgData name="由美子 秋田" userId="982681295766d2be" providerId="LiveId" clId="{81DC723C-AF0E-4E57-9BD4-9DF701AD38B1}" dt="2024-12-03T05:54:45.920" v="179" actId="1076"/>
        <pc:sldMkLst>
          <pc:docMk/>
          <pc:sldMk cId="910199644" sldId="262"/>
        </pc:sldMkLst>
        <pc:spChg chg="mod">
          <ac:chgData name="由美子 秋田" userId="982681295766d2be" providerId="LiveId" clId="{81DC723C-AF0E-4E57-9BD4-9DF701AD38B1}" dt="2024-12-03T04:04:32.119" v="63" actId="20577"/>
          <ac:spMkLst>
            <pc:docMk/>
            <pc:sldMk cId="910199644" sldId="262"/>
            <ac:spMk id="209" creationId="{20EB5611-49F3-3B5B-820D-AFA9E283615F}"/>
          </ac:spMkLst>
        </pc:spChg>
        <pc:spChg chg="mod">
          <ac:chgData name="由美子 秋田" userId="982681295766d2be" providerId="LiveId" clId="{81DC723C-AF0E-4E57-9BD4-9DF701AD38B1}" dt="2024-12-03T05:51:53.145" v="167" actId="2711"/>
          <ac:spMkLst>
            <pc:docMk/>
            <pc:sldMk cId="910199644" sldId="262"/>
            <ac:spMk id="334" creationId="{F7CEB950-189F-3C1A-0BC6-310451471A52}"/>
          </ac:spMkLst>
        </pc:spChg>
        <pc:spChg chg="mod">
          <ac:chgData name="由美子 秋田" userId="982681295766d2be" providerId="LiveId" clId="{81DC723C-AF0E-4E57-9BD4-9DF701AD38B1}" dt="2024-12-03T05:54:45.920" v="179" actId="1076"/>
          <ac:spMkLst>
            <pc:docMk/>
            <pc:sldMk cId="910199644" sldId="262"/>
            <ac:spMk id="335" creationId="{84EE6701-2847-9BEE-E984-A41B1F9FF528}"/>
          </ac:spMkLst>
        </pc:spChg>
      </pc:sldChg>
      <pc:sldChg chg="addSp delSp modSp mod modNotesTx">
        <pc:chgData name="由美子 秋田" userId="982681295766d2be" providerId="LiveId" clId="{81DC723C-AF0E-4E57-9BD4-9DF701AD38B1}" dt="2024-12-03T05:55:52.713" v="190" actId="1076"/>
        <pc:sldMkLst>
          <pc:docMk/>
          <pc:sldMk cId="1041882890" sldId="268"/>
        </pc:sldMkLst>
        <pc:spChg chg="mod">
          <ac:chgData name="由美子 秋田" userId="982681295766d2be" providerId="LiveId" clId="{81DC723C-AF0E-4E57-9BD4-9DF701AD38B1}" dt="2024-12-03T05:55:52.713" v="190" actId="1076"/>
          <ac:spMkLst>
            <pc:docMk/>
            <pc:sldMk cId="1041882890" sldId="268"/>
            <ac:spMk id="2" creationId="{71DA512D-9143-B83C-E5F3-9165E4E1645E}"/>
          </ac:spMkLst>
        </pc:spChg>
        <pc:spChg chg="mod">
          <ac:chgData name="由美子 秋田" userId="982681295766d2be" providerId="LiveId" clId="{81DC723C-AF0E-4E57-9BD4-9DF701AD38B1}" dt="2024-12-03T05:52:37.245" v="172" actId="1076"/>
          <ac:spMkLst>
            <pc:docMk/>
            <pc:sldMk cId="1041882890" sldId="268"/>
            <ac:spMk id="4" creationId="{1E07D607-362D-9C57-5868-537DBF29A0DC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6" creationId="{0E68BE50-2496-2FBB-BD97-8DB644B5FB9D}"/>
          </ac:spMkLst>
        </pc:spChg>
        <pc:spChg chg="mod">
          <ac:chgData name="由美子 秋田" userId="982681295766d2be" providerId="LiveId" clId="{81DC723C-AF0E-4E57-9BD4-9DF701AD38B1}" dt="2024-12-03T05:39:36.014" v="132" actId="1076"/>
          <ac:spMkLst>
            <pc:docMk/>
            <pc:sldMk cId="1041882890" sldId="268"/>
            <ac:spMk id="7" creationId="{4470710E-5513-FB68-5318-52D55AE7FF62}"/>
          </ac:spMkLst>
        </pc:spChg>
        <pc:spChg chg="mod">
          <ac:chgData name="由美子 秋田" userId="982681295766d2be" providerId="LiveId" clId="{81DC723C-AF0E-4E57-9BD4-9DF701AD38B1}" dt="2024-12-03T05:39:47.814" v="133" actId="1076"/>
          <ac:spMkLst>
            <pc:docMk/>
            <pc:sldMk cId="1041882890" sldId="268"/>
            <ac:spMk id="8" creationId="{7F30F085-EE0C-7215-F93F-09FDEA8A96F2}"/>
          </ac:spMkLst>
        </pc:spChg>
        <pc:spChg chg="mod">
          <ac:chgData name="由美子 秋田" userId="982681295766d2be" providerId="LiveId" clId="{81DC723C-AF0E-4E57-9BD4-9DF701AD38B1}" dt="2024-12-03T05:38:06.407" v="98" actId="20577"/>
          <ac:spMkLst>
            <pc:docMk/>
            <pc:sldMk cId="1041882890" sldId="268"/>
            <ac:spMk id="9" creationId="{2D951796-C524-98B9-435B-63178013A495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0" creationId="{A3F3D2B1-9122-0D89-1EEA-86E9E213751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1" creationId="{3548B7A1-BDA5-4BD4-E7CE-514C6CC02B25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2" creationId="{2061E68D-0843-8386-7085-555CBC683EE4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3" creationId="{9C6E5365-AAEB-2716-599F-E9D9473383BB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4" creationId="{A2F9AADF-A39D-E4C3-635D-4BB2BA733221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5" creationId="{601A11E5-627F-4578-AE3D-D6838C48628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6" creationId="{7C1C7B0F-82B1-5BDE-835E-B34F6EF6BF4E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7" creationId="{5943966F-7938-6769-4AB1-BA1A84919D57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8" creationId="{F0DCB5E9-4B2E-A6EC-8E41-8E467953275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9" creationId="{194717C4-B7F9-4B8A-0E40-E5E4EEE530F9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20" creationId="{A746874F-A44A-CD08-AA01-E5F463E0897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21" creationId="{8D8F7D21-D9F9-1D1E-DB2C-2EF661D250D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22" creationId="{EA5EF4F5-68A3-B211-8AFD-A1AA83163B32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23" creationId="{6A33B3F9-65EB-0AA7-F284-6B2D8AFC3CA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24" creationId="{4F94A6F0-0350-DE6B-A828-8260991336E8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25" creationId="{758BDAAA-FEB7-9656-37FA-27E19564316E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26" creationId="{650A68F9-5800-B91B-3D64-2517F55BD59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27" creationId="{1446C49C-84C1-C0E5-29BA-58403EE2A702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28" creationId="{110EE78C-E53A-8501-2AE5-5AABC00750F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29" creationId="{1878BB19-FDDC-5C80-81C2-7D10A93FEA6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30" creationId="{1B7A85E3-197D-2A7B-1852-61AA14134534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31" creationId="{62B76725-C7EC-30D6-3935-E884784192EA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32" creationId="{27C31086-0977-D727-1085-897F596A05A7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33" creationId="{A00DD194-D1DF-7BB8-8D56-97EEAEE31004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34" creationId="{F5886CE1-8F6E-C4D6-A8D8-D7B406B76A71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35" creationId="{B0C55FCE-2F79-D0B5-FBB9-F355E58007B5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36" creationId="{5351F8EE-7695-8E78-CB12-8A4F8A757616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37" creationId="{58689724-C16F-197D-DE92-7007B40C40E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38" creationId="{54E8116B-2D38-5BC1-FFE1-1497FDAB6407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39" creationId="{5FA2E691-0495-8E8C-CB3E-4BF45BF20ACA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40" creationId="{CA8BBEC3-8071-749B-C7CF-11B58E6677A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41" creationId="{C38417C8-3766-C612-37A4-4815709B720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42" creationId="{1B779453-CDFB-50AB-D63F-8FD1A4799F3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43" creationId="{D0C79005-A63E-1AE8-2EE5-C7467443F80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44" creationId="{3C61C551-0399-774C-E195-34712354B8FE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45" creationId="{7043C99F-DC3C-AEC8-74EC-97C52E9623AB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46" creationId="{39C1612D-3078-B16E-5210-CDB6C24B278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47" creationId="{286079A7-8F39-6CBC-B146-2D3CD4111AA6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48" creationId="{D469DFE8-6B7A-D2BD-B9E1-4DC0E3C5DF6A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49" creationId="{77250DA1-18C2-90FE-9118-6A19FE5B0EB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50" creationId="{7F4C611F-012C-1E84-D821-363FD8FE789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51" creationId="{EFE5A01B-B8A1-14A1-E6AA-6328A0910F8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52" creationId="{17B789D6-2EC0-74E1-E3DC-F64B7D02727A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53" creationId="{9F1A27C4-36B2-781F-952D-79E9386D83B6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54" creationId="{E1FC02D4-A489-F221-3BE2-3578D59F8D01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55" creationId="{06827A7B-AF19-A529-BDA5-CC852F07F1BE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56" creationId="{30E6D699-CBFB-4655-563E-F839A761270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57" creationId="{F579F60D-A1EA-EEA1-73CE-DF9A2FFFAF55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58" creationId="{77775F2B-4E7A-E2F2-324E-5C7537EB29E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59" creationId="{E2C887F6-B14E-BA02-9F57-503D54D7AE5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60" creationId="{3A3244AD-C724-1E2D-DC90-27D38731685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61" creationId="{1CC70F31-737F-2ADF-EC39-2DCAF638B02C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62" creationId="{25042257-9614-A208-27B9-3A90929F4F5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63" creationId="{72DC3579-82D2-4640-8F9A-A868D05F3362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64" creationId="{D20A56EB-F9A3-C8FC-CE20-FB8B675BE374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65" creationId="{C71B2E78-6525-53AF-08ED-A5CE1D65AAFA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66" creationId="{3933C171-091D-1BD6-AE7E-36E1020FB654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67" creationId="{5D949D6F-F804-1695-1E18-D49713336065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68" creationId="{BFC3A43D-B9FB-788C-AFE6-8EE3C30E5291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69" creationId="{5B3EA984-02FB-B3D5-7E72-FA0DACC4FC85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70" creationId="{083FBFA5-EF78-AA90-108F-548FC749AAC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71" creationId="{44D0ED66-6E14-B3A5-8BC9-6D6D37016AE4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72" creationId="{0D19E9F6-8C72-242F-5036-953678BB06DB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73" creationId="{E3C9E271-DB80-EF9D-E4E6-3D0DF886111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74" creationId="{EF8C451D-D4E4-ED34-5F5B-BAB7284EDBD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75" creationId="{57A79AB3-0378-D4F3-1343-A770C4EE829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76" creationId="{9EED9595-39AF-2F2F-9C57-1E8D093EB379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77" creationId="{1354ED47-75F8-900D-3F51-75D072A64A11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78" creationId="{B4EB918E-2C56-BF47-9FA4-B9154A9C2669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79" creationId="{A61FABD7-1ACB-9332-7C68-5AE7DB4210D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80" creationId="{D6028B3D-1FE2-4CD8-FB5F-BD44229E0D3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81" creationId="{97B3965B-90DF-1AA3-8C32-7AE260A999A6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82" creationId="{53FF2089-FA38-2791-0F90-289E24E24977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83" creationId="{500AC710-9D45-FCD5-DAFA-7D463BCAB949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84" creationId="{5F51152A-DC4B-5384-FD9A-65DE2F193D0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85" creationId="{2AC721F9-CFEE-1AB1-4B87-FCB23AEEC145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86" creationId="{2AA67CEF-3DEF-9C56-FBA6-27DD252418F5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87" creationId="{A1EF4F7E-3042-B3D7-7D42-0B467E687C79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88" creationId="{6B27A649-44CE-CA27-1D51-8D835B035F8C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89" creationId="{16D6CD20-D0D9-A388-DFDE-0CE16E0EE48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90" creationId="{AD53134C-7197-6DAF-BBC4-753066D5DF4E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91" creationId="{B503A556-1626-D2A7-0E8C-76715D27C8C9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92" creationId="{C4E9D711-53FE-993F-6D53-D5937FC4EEEE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93" creationId="{A2B717E3-6AFF-5FEA-DD22-025E364B8BB9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94" creationId="{624EF333-ABCC-A537-50CD-BAA26F8BD581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95" creationId="{EC8DC624-B1D1-C418-BB53-5A010C59F34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96" creationId="{C8AEB1BE-EDDD-AC98-FF87-16A63BE88B65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97" creationId="{6ADFF903-2A85-2C23-3A18-A84A0643AD2A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98" creationId="{2F6AAB75-D93E-452F-6992-BD4A2721D60C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99" creationId="{07D375F9-B2EA-CDA6-9419-00C74B239A76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00" creationId="{608FE972-F3CB-006C-8DF7-6A24CEC1DC9E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01" creationId="{64E3C638-83B3-C7AB-B69C-BF87DF390FE8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02" creationId="{03552CC2-9259-1615-548F-A83240278EB9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03" creationId="{601BA2C6-817B-6C42-C17E-EB973CBC60FB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04" creationId="{3547F413-B794-88A8-653C-A6A3363F7A7C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05" creationId="{DE7C415E-EB2B-E56A-E521-BB40F6569B35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06" creationId="{CAF97931-8AD6-ABB4-2C80-496B2B74864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07" creationId="{B08F5DE2-DDCD-AA5C-2729-9CE3AFE231AB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08" creationId="{C99CC6D8-F816-2264-CCBD-80269A0C3DAA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09" creationId="{5E0945A9-3EE4-7556-1AF1-E35266A94D2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10" creationId="{946CE947-C608-C269-682A-7DD9FF4DADC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11" creationId="{8F6E383F-B491-97C1-61AB-E019AE63EBB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12" creationId="{2EB3089D-D308-529C-8AB8-A3B0276E1DA8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13" creationId="{E35DE660-5C1B-6577-2055-7326EB06285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14" creationId="{9A803B2B-E0D2-2222-E9F5-49BBB5A8398A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15" creationId="{278ED06C-126D-2439-CCCB-EB153332B631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16" creationId="{B8C87DB7-A0F4-8735-8A85-DB50563746C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17" creationId="{5F83BC31-DD53-7166-BA14-9C8D5A95853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18" creationId="{CB229081-60FA-6648-8426-79EC355B8F9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19" creationId="{817277DD-74BD-9060-C1AC-91580D601324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20" creationId="{E854BE00-26CB-6C60-D1CC-978DFB3CD1CB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21" creationId="{2E54BFE0-7EDA-E502-0FED-894B6D9F287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22" creationId="{211AB04A-03A4-172D-0CED-FDD7419F7218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23" creationId="{D843C32B-AEFE-5689-CAF5-D1F070DC7326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24" creationId="{EDE40C8A-D755-F1A6-481C-F244A325EF3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25" creationId="{E86572BD-2407-2730-ACE0-479879F0520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26" creationId="{7EBA0FAB-D67B-CFAB-45DD-348469CA7ED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27" creationId="{35328054-B8C1-BC04-6013-057F1E94537C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28" creationId="{B78E1AEB-C486-1BD3-5623-EF36DA69574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29" creationId="{C0ADAC72-5CC1-8AC5-4CAD-D52CF8BA71D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30" creationId="{90508957-0BEE-D6EC-B1F0-46904B0108A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31" creationId="{43F79D21-C3E1-D3B4-3175-55D0247C97F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32" creationId="{CF7C462E-F495-C48D-8FD7-DA7DB4B631F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33" creationId="{08734C48-3946-3971-1226-4516E2D368A9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34" creationId="{E276C607-7BD4-8B37-2CEC-5F7C48751B3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35" creationId="{1F05645F-CD09-3491-F728-8F75D6EC6A27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36" creationId="{7C4FE899-C8FB-3D6C-F929-5E8C425B6F7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37" creationId="{649D9E93-65D8-466E-6485-008066C1CD6C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38" creationId="{1568C2FD-B167-955D-946E-658ADD1C7ED7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39" creationId="{FB6B3D0C-A91B-84AE-5625-789DDF66899B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40" creationId="{0DBDC9AE-0C01-3449-D1B0-C48EE604E74B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41" creationId="{242AFFAD-4FD4-C8A1-0B09-18CDCCD03EB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42" creationId="{A7EBC961-189F-B9AC-195C-C7960E701472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43" creationId="{4EE74154-39CB-CF2F-628A-DE90BAA8E6F4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44" creationId="{2FAB05A0-8CEF-3DCA-6E2D-D4837BC6FCE6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45" creationId="{47746F69-4621-A601-795D-71569824CE16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46" creationId="{7672B23C-2FDC-70AF-450D-BBA3CB561E58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47" creationId="{B40411B0-11E5-03D8-8160-B86309AE494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48" creationId="{A3A85E23-60A4-3B44-012C-DAE4A44CB5C7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49" creationId="{EA19D15B-E121-7D50-EA1B-690512FC19FE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50" creationId="{C56CBCDB-1F4C-BF1E-455F-04DC43DDA40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51" creationId="{59BCD53E-0F16-1BCA-29D0-2C5986D48E8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52" creationId="{598BCB65-05D1-E973-7146-FF9D3452DC77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53" creationId="{C0BB5923-1F3E-8145-C619-D8D945458BAC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54" creationId="{3097D5AA-E518-2503-6BA3-E9FC93195EC1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55" creationId="{AA5048E5-0D78-D772-C710-77DF853527D1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56" creationId="{E2976E81-93C9-EB0C-7F9D-6598FB5937CB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57" creationId="{B07E8AD4-4B2B-4C1B-B532-8E79FA0949A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58" creationId="{9B62E844-DF1A-03C0-DF75-FDB04DDA7C03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59" creationId="{273A2FA5-CE83-D196-5830-53ED7BBE8445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60" creationId="{E6B170FC-8225-2FAF-92B1-C6996CF27FDA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61" creationId="{EB380C69-F3E7-B57B-55CD-663C2EBDA01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62" creationId="{6D119FF0-296E-E76D-85A4-A54A0EA3D987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63" creationId="{E99BB3EE-0FB3-ECE5-C9AA-5F93B616BFEB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64" creationId="{81EBF98A-B6D5-91AC-24E2-6436F5B8DA16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65" creationId="{43CA35E2-92EE-DC7A-7046-6F246BFA1DD1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66" creationId="{2004EBC7-F1D6-008E-9888-62A12C20021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67" creationId="{A3313A41-F6B8-0EBB-171D-A608C8D19806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68" creationId="{FBAEA8B8-FB2D-0B6B-5F38-8A67646280FF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69" creationId="{25D40AEA-C3D1-5B9A-A895-7EB13938E608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70" creationId="{E28959B7-8E13-8A1B-2ED9-B0D8EDFEAB22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71" creationId="{79BE65B8-57E4-E393-5844-63CE9C905CCA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72" creationId="{3E9BF9D7-9960-80EE-81AA-DF8841817F5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73" creationId="{1F17711F-4DAA-C311-B401-497AFCAF0A1A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74" creationId="{E3F71B8E-831C-4CD1-4CC8-667277AF450C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75" creationId="{573E9953-1791-CAB9-13DD-E8682551401E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76" creationId="{7278CE68-F2A3-758C-077F-3EB289C91D1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77" creationId="{8AE1E481-5C4E-F39C-4019-BD186A676879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78" creationId="{F640B3A6-3084-B793-5B28-247616AE3C39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79" creationId="{D3608C72-B532-6AB9-619E-862A03E1592B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80" creationId="{B6470391-59FD-3527-E99A-7CCAB8B849ED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81" creationId="{239631AA-3FBB-25E0-4C45-86B7DF2FAA40}"/>
          </ac:spMkLst>
        </pc:spChg>
        <pc:spChg chg="mod">
          <ac:chgData name="由美子 秋田" userId="982681295766d2be" providerId="LiveId" clId="{81DC723C-AF0E-4E57-9BD4-9DF701AD38B1}" dt="2024-12-03T04:03:12.877" v="47" actId="14100"/>
          <ac:spMkLst>
            <pc:docMk/>
            <pc:sldMk cId="1041882890" sldId="268"/>
            <ac:spMk id="182" creationId="{73259F0D-C346-9A25-5E1C-F4B15726658B}"/>
          </ac:spMkLst>
        </pc:spChg>
        <pc:spChg chg="add mod">
          <ac:chgData name="由美子 秋田" userId="982681295766d2be" providerId="LiveId" clId="{81DC723C-AF0E-4E57-9BD4-9DF701AD38B1}" dt="2024-12-03T04:04:00.767" v="57" actId="113"/>
          <ac:spMkLst>
            <pc:docMk/>
            <pc:sldMk cId="1041882890" sldId="268"/>
            <ac:spMk id="184" creationId="{1DAFE9C3-DA1F-13BB-A9AF-DC587A542FC0}"/>
          </ac:spMkLst>
        </pc:spChg>
        <pc:grpChg chg="add mod">
          <ac:chgData name="由美子 秋田" userId="982681295766d2be" providerId="LiveId" clId="{81DC723C-AF0E-4E57-9BD4-9DF701AD38B1}" dt="2024-12-03T04:03:12.877" v="47" actId="14100"/>
          <ac:grpSpMkLst>
            <pc:docMk/>
            <pc:sldMk cId="1041882890" sldId="268"/>
            <ac:grpSpMk id="5" creationId="{C1D45115-C483-4289-6C3E-A8EDF4243300}"/>
          </ac:grpSpMkLst>
        </pc:grpChg>
      </pc:sldChg>
      <pc:sldChg chg="modSp mod modNotesTx">
        <pc:chgData name="由美子 秋田" userId="982681295766d2be" providerId="LiveId" clId="{81DC723C-AF0E-4E57-9BD4-9DF701AD38B1}" dt="2024-12-03T05:58:50.196" v="211" actId="255"/>
        <pc:sldMkLst>
          <pc:docMk/>
          <pc:sldMk cId="1634665014" sldId="301"/>
        </pc:sldMkLst>
        <pc:spChg chg="mod">
          <ac:chgData name="由美子 秋田" userId="982681295766d2be" providerId="LiveId" clId="{81DC723C-AF0E-4E57-9BD4-9DF701AD38B1}" dt="2024-12-03T05:47:46.708" v="150" actId="2711"/>
          <ac:spMkLst>
            <pc:docMk/>
            <pc:sldMk cId="1634665014" sldId="301"/>
            <ac:spMk id="3" creationId="{F276830E-8A0B-941C-B87B-1EE0FF24999A}"/>
          </ac:spMkLst>
        </pc:spChg>
        <pc:spChg chg="mod">
          <ac:chgData name="由美子 秋田" userId="982681295766d2be" providerId="LiveId" clId="{81DC723C-AF0E-4E57-9BD4-9DF701AD38B1}" dt="2024-12-03T05:58:31.630" v="207" actId="255"/>
          <ac:spMkLst>
            <pc:docMk/>
            <pc:sldMk cId="1634665014" sldId="301"/>
            <ac:spMk id="4" creationId="{2EBF818F-440F-78DA-854C-3EF66A16DF93}"/>
          </ac:spMkLst>
        </pc:spChg>
        <pc:spChg chg="mod">
          <ac:chgData name="由美子 秋田" userId="982681295766d2be" providerId="LiveId" clId="{81DC723C-AF0E-4E57-9BD4-9DF701AD38B1}" dt="2024-12-03T05:58:40.985" v="209" actId="255"/>
          <ac:spMkLst>
            <pc:docMk/>
            <pc:sldMk cId="1634665014" sldId="301"/>
            <ac:spMk id="6" creationId="{1184DF46-F78E-784D-77D3-8901F270EF16}"/>
          </ac:spMkLst>
        </pc:spChg>
        <pc:spChg chg="mod">
          <ac:chgData name="由美子 秋田" userId="982681295766d2be" providerId="LiveId" clId="{81DC723C-AF0E-4E57-9BD4-9DF701AD38B1}" dt="2024-12-03T05:58:50.196" v="211" actId="255"/>
          <ac:spMkLst>
            <pc:docMk/>
            <pc:sldMk cId="1634665014" sldId="301"/>
            <ac:spMk id="12" creationId="{7ABAEA4B-7177-5865-B918-C9BDB884F770}"/>
          </ac:spMkLst>
        </pc:spChg>
      </pc:sldChg>
      <pc:sldChg chg="modSp mod">
        <pc:chgData name="由美子 秋田" userId="982681295766d2be" providerId="LiveId" clId="{81DC723C-AF0E-4E57-9BD4-9DF701AD38B1}" dt="2024-12-03T05:55:02.704" v="182" actId="1076"/>
        <pc:sldMkLst>
          <pc:docMk/>
          <pc:sldMk cId="4164275393" sldId="312"/>
        </pc:sldMkLst>
        <pc:spChg chg="mod">
          <ac:chgData name="由美子 秋田" userId="982681295766d2be" providerId="LiveId" clId="{81DC723C-AF0E-4E57-9BD4-9DF701AD38B1}" dt="2024-12-03T05:55:02.704" v="182" actId="1076"/>
          <ac:spMkLst>
            <pc:docMk/>
            <pc:sldMk cId="4164275393" sldId="312"/>
            <ac:spMk id="2" creationId="{22855E6E-AFA3-33C0-C5C4-1DC6D886AEEB}"/>
          </ac:spMkLst>
        </pc:spChg>
        <pc:spChg chg="mod">
          <ac:chgData name="由美子 秋田" userId="982681295766d2be" providerId="LiveId" clId="{81DC723C-AF0E-4E57-9BD4-9DF701AD38B1}" dt="2024-12-03T05:51:35.259" v="165" actId="2711"/>
          <ac:spMkLst>
            <pc:docMk/>
            <pc:sldMk cId="4164275393" sldId="312"/>
            <ac:spMk id="5" creationId="{244CD741-B7EB-4B69-F1D6-380EB7938752}"/>
          </ac:spMkLst>
        </pc:spChg>
      </pc:sldChg>
      <pc:sldChg chg="modSp mod">
        <pc:chgData name="由美子 秋田" userId="982681295766d2be" providerId="LiveId" clId="{81DC723C-AF0E-4E57-9BD4-9DF701AD38B1}" dt="2024-12-03T05:55:28.976" v="186" actId="255"/>
        <pc:sldMkLst>
          <pc:docMk/>
          <pc:sldMk cId="3204364479" sldId="313"/>
        </pc:sldMkLst>
        <pc:spChg chg="mod">
          <ac:chgData name="由美子 秋田" userId="982681295766d2be" providerId="LiveId" clId="{81DC723C-AF0E-4E57-9BD4-9DF701AD38B1}" dt="2024-12-03T05:51:25.085" v="163" actId="2711"/>
          <ac:spMkLst>
            <pc:docMk/>
            <pc:sldMk cId="3204364479" sldId="313"/>
            <ac:spMk id="2" creationId="{5FEFAF4A-E9D3-29DD-887D-B1A265AE96C6}"/>
          </ac:spMkLst>
        </pc:spChg>
        <pc:spChg chg="mod">
          <ac:chgData name="由美子 秋田" userId="982681295766d2be" providerId="LiveId" clId="{81DC723C-AF0E-4E57-9BD4-9DF701AD38B1}" dt="2024-12-03T05:55:14.316" v="184" actId="255"/>
          <ac:spMkLst>
            <pc:docMk/>
            <pc:sldMk cId="3204364479" sldId="313"/>
            <ac:spMk id="246" creationId="{6F0A26E1-BE67-E326-6B84-258620743C28}"/>
          </ac:spMkLst>
        </pc:spChg>
        <pc:spChg chg="mod">
          <ac:chgData name="由美子 秋田" userId="982681295766d2be" providerId="LiveId" clId="{81DC723C-AF0E-4E57-9BD4-9DF701AD38B1}" dt="2024-12-03T05:55:28.976" v="186" actId="255"/>
          <ac:spMkLst>
            <pc:docMk/>
            <pc:sldMk cId="3204364479" sldId="313"/>
            <ac:spMk id="247" creationId="{6CA538E1-84D4-1834-BBF3-ADDA8B43F61A}"/>
          </ac:spMkLst>
        </pc:spChg>
      </pc:sldChg>
      <pc:sldChg chg="modSp mod">
        <pc:chgData name="由美子 秋田" userId="982681295766d2be" providerId="LiveId" clId="{81DC723C-AF0E-4E57-9BD4-9DF701AD38B1}" dt="2024-12-03T06:42:31.016" v="224" actId="2711"/>
        <pc:sldMkLst>
          <pc:docMk/>
          <pc:sldMk cId="1674619836" sldId="314"/>
        </pc:sldMkLst>
        <pc:spChg chg="mod">
          <ac:chgData name="由美子 秋田" userId="982681295766d2be" providerId="LiveId" clId="{81DC723C-AF0E-4E57-9BD4-9DF701AD38B1}" dt="2024-12-03T05:51:08.742" v="161" actId="2711"/>
          <ac:spMkLst>
            <pc:docMk/>
            <pc:sldMk cId="1674619836" sldId="314"/>
            <ac:spMk id="2" creationId="{9FFD8F6C-1158-2CB6-7F6E-1A0DA4DF925C}"/>
          </ac:spMkLst>
        </pc:spChg>
        <pc:spChg chg="mod">
          <ac:chgData name="由美子 秋田" userId="982681295766d2be" providerId="LiveId" clId="{81DC723C-AF0E-4E57-9BD4-9DF701AD38B1}" dt="2024-12-03T06:42:31.016" v="224" actId="2711"/>
          <ac:spMkLst>
            <pc:docMk/>
            <pc:sldMk cId="1674619836" sldId="314"/>
            <ac:spMk id="229" creationId="{9DF30197-8966-B6C4-EC84-FB6869F5BBFE}"/>
          </ac:spMkLst>
        </pc:spChg>
        <pc:spChg chg="mod">
          <ac:chgData name="由美子 秋田" userId="982681295766d2be" providerId="LiveId" clId="{81DC723C-AF0E-4E57-9BD4-9DF701AD38B1}" dt="2024-12-03T05:56:33.729" v="194" actId="2711"/>
          <ac:spMkLst>
            <pc:docMk/>
            <pc:sldMk cId="1674619836" sldId="314"/>
            <ac:spMk id="230" creationId="{15D4DC24-63C4-81B2-D57D-50941E365063}"/>
          </ac:spMkLst>
        </pc:spChg>
      </pc:sldChg>
      <pc:sldChg chg="modSp mod">
        <pc:chgData name="由美子 秋田" userId="982681295766d2be" providerId="LiveId" clId="{81DC723C-AF0E-4E57-9BD4-9DF701AD38B1}" dt="2024-12-03T05:52:21.072" v="171" actId="2711"/>
        <pc:sldMkLst>
          <pc:docMk/>
          <pc:sldMk cId="675113385" sldId="321"/>
        </pc:sldMkLst>
        <pc:spChg chg="mod">
          <ac:chgData name="由美子 秋田" userId="982681295766d2be" providerId="LiveId" clId="{81DC723C-AF0E-4E57-9BD4-9DF701AD38B1}" dt="2024-12-03T05:52:21.072" v="171" actId="2711"/>
          <ac:spMkLst>
            <pc:docMk/>
            <pc:sldMk cId="675113385" sldId="321"/>
            <ac:spMk id="2" creationId="{05EF1C3C-8D1F-E236-9CD3-1F2C618463C4}"/>
          </ac:spMkLst>
        </pc:spChg>
        <pc:spChg chg="mod">
          <ac:chgData name="由美子 秋田" userId="982681295766d2be" providerId="LiveId" clId="{81DC723C-AF0E-4E57-9BD4-9DF701AD38B1}" dt="2024-12-03T05:37:02.517" v="82" actId="20577"/>
          <ac:spMkLst>
            <pc:docMk/>
            <pc:sldMk cId="675113385" sldId="321"/>
            <ac:spMk id="5" creationId="{949D8E96-E56D-3448-7682-E7DD7052F634}"/>
          </ac:spMkLst>
        </pc:spChg>
        <pc:spChg chg="mod">
          <ac:chgData name="由美子 秋田" userId="982681295766d2be" providerId="LiveId" clId="{81DC723C-AF0E-4E57-9BD4-9DF701AD38B1}" dt="2024-12-03T05:41:53.361" v="140" actId="20577"/>
          <ac:spMkLst>
            <pc:docMk/>
            <pc:sldMk cId="675113385" sldId="321"/>
            <ac:spMk id="13" creationId="{1BE9E3CF-B052-1A22-FE13-1F36A3556136}"/>
          </ac:spMkLst>
        </pc:spChg>
        <pc:spChg chg="mod">
          <ac:chgData name="由美子 秋田" userId="982681295766d2be" providerId="LiveId" clId="{81DC723C-AF0E-4E57-9BD4-9DF701AD38B1}" dt="2024-12-03T05:41:17.533" v="136" actId="20577"/>
          <ac:spMkLst>
            <pc:docMk/>
            <pc:sldMk cId="675113385" sldId="321"/>
            <ac:spMk id="14" creationId="{DFA435CC-AEEC-35B0-6F23-9A617C7B5FE8}"/>
          </ac:spMkLst>
        </pc:spChg>
        <pc:spChg chg="mod">
          <ac:chgData name="由美子 秋田" userId="982681295766d2be" providerId="LiveId" clId="{81DC723C-AF0E-4E57-9BD4-9DF701AD38B1}" dt="2024-12-03T03:53:51.660" v="2" actId="255"/>
          <ac:spMkLst>
            <pc:docMk/>
            <pc:sldMk cId="675113385" sldId="321"/>
            <ac:spMk id="15" creationId="{3D8D45D1-85DB-0066-3937-D9DDFE3EC5A0}"/>
          </ac:spMkLst>
        </pc:spChg>
        <pc:spChg chg="mod">
          <ac:chgData name="由美子 秋田" userId="982681295766d2be" providerId="LiveId" clId="{81DC723C-AF0E-4E57-9BD4-9DF701AD38B1}" dt="2024-12-03T05:42:28.114" v="142" actId="20577"/>
          <ac:spMkLst>
            <pc:docMk/>
            <pc:sldMk cId="675113385" sldId="321"/>
            <ac:spMk id="16" creationId="{267C32DA-9729-F14E-FEF7-1BCA32AF5B11}"/>
          </ac:spMkLst>
        </pc:spChg>
        <pc:spChg chg="mod">
          <ac:chgData name="由美子 秋田" userId="982681295766d2be" providerId="LiveId" clId="{81DC723C-AF0E-4E57-9BD4-9DF701AD38B1}" dt="2024-12-03T03:54:23.845" v="9" actId="20577"/>
          <ac:spMkLst>
            <pc:docMk/>
            <pc:sldMk cId="675113385" sldId="321"/>
            <ac:spMk id="17" creationId="{40C954B0-4DEB-1A7E-33EC-49C833D131D2}"/>
          </ac:spMkLst>
        </pc:spChg>
        <pc:spChg chg="mod">
          <ac:chgData name="由美子 秋田" userId="982681295766d2be" providerId="LiveId" clId="{81DC723C-AF0E-4E57-9BD4-9DF701AD38B1}" dt="2024-12-03T03:54:38.253" v="11" actId="255"/>
          <ac:spMkLst>
            <pc:docMk/>
            <pc:sldMk cId="675113385" sldId="321"/>
            <ac:spMk id="18" creationId="{9ED877DD-0DBD-8541-113B-8EED415C5F74}"/>
          </ac:spMkLst>
        </pc:spChg>
        <pc:spChg chg="mod">
          <ac:chgData name="由美子 秋田" userId="982681295766d2be" providerId="LiveId" clId="{81DC723C-AF0E-4E57-9BD4-9DF701AD38B1}" dt="2024-12-03T05:41:33.287" v="138" actId="20577"/>
          <ac:spMkLst>
            <pc:docMk/>
            <pc:sldMk cId="675113385" sldId="321"/>
            <ac:spMk id="19" creationId="{DA2B9B65-E4C5-539A-C458-66835510632B}"/>
          </ac:spMkLst>
        </pc:spChg>
      </pc:sldChg>
      <pc:sldChg chg="modSp mod">
        <pc:chgData name="由美子 秋田" userId="982681295766d2be" providerId="LiveId" clId="{81DC723C-AF0E-4E57-9BD4-9DF701AD38B1}" dt="2024-12-03T05:57:51.166" v="203" actId="27636"/>
        <pc:sldMkLst>
          <pc:docMk/>
          <pc:sldMk cId="3912212708" sldId="340"/>
        </pc:sldMkLst>
        <pc:spChg chg="mod">
          <ac:chgData name="由美子 秋田" userId="982681295766d2be" providerId="LiveId" clId="{81DC723C-AF0E-4E57-9BD4-9DF701AD38B1}" dt="2024-12-03T05:57:42.538" v="200" actId="2711"/>
          <ac:spMkLst>
            <pc:docMk/>
            <pc:sldMk cId="3912212708" sldId="340"/>
            <ac:spMk id="4" creationId="{1755B266-45A6-FE85-FBE2-F13FB5526B83}"/>
          </ac:spMkLst>
        </pc:spChg>
        <pc:spChg chg="mod">
          <ac:chgData name="由美子 秋田" userId="982681295766d2be" providerId="LiveId" clId="{81DC723C-AF0E-4E57-9BD4-9DF701AD38B1}" dt="2024-12-03T05:50:37.367" v="158" actId="1076"/>
          <ac:spMkLst>
            <pc:docMk/>
            <pc:sldMk cId="3912212708" sldId="340"/>
            <ac:spMk id="6" creationId="{D8475D83-08CC-8865-5252-5C6A6704B2ED}"/>
          </ac:spMkLst>
        </pc:spChg>
        <pc:spChg chg="mod">
          <ac:chgData name="由美子 秋田" userId="982681295766d2be" providerId="LiveId" clId="{81DC723C-AF0E-4E57-9BD4-9DF701AD38B1}" dt="2024-12-03T05:57:51.166" v="203" actId="27636"/>
          <ac:spMkLst>
            <pc:docMk/>
            <pc:sldMk cId="3912212708" sldId="340"/>
            <ac:spMk id="7" creationId="{49D563ED-9F03-1670-763C-E72ECD64451E}"/>
          </ac:spMkLst>
        </pc:spChg>
      </pc:sldChg>
      <pc:sldChg chg="modSp mod">
        <pc:chgData name="由美子 秋田" userId="982681295766d2be" providerId="LiveId" clId="{81DC723C-AF0E-4E57-9BD4-9DF701AD38B1}" dt="2024-12-03T06:44:49.740" v="229" actId="255"/>
        <pc:sldMkLst>
          <pc:docMk/>
          <pc:sldMk cId="729325973" sldId="343"/>
        </pc:sldMkLst>
        <pc:spChg chg="mod">
          <ac:chgData name="由美子 秋田" userId="982681295766d2be" providerId="LiveId" clId="{81DC723C-AF0E-4E57-9BD4-9DF701AD38B1}" dt="2024-12-03T06:00:03.386" v="223" actId="20577"/>
          <ac:spMkLst>
            <pc:docMk/>
            <pc:sldMk cId="729325973" sldId="343"/>
            <ac:spMk id="5" creationId="{2E6A134F-4F5E-D8F3-606D-6C55C59949FA}"/>
          </ac:spMkLst>
        </pc:spChg>
        <pc:spChg chg="mod">
          <ac:chgData name="由美子 秋田" userId="982681295766d2be" providerId="LiveId" clId="{81DC723C-AF0E-4E57-9BD4-9DF701AD38B1}" dt="2024-12-03T06:44:44.538" v="228" actId="255"/>
          <ac:spMkLst>
            <pc:docMk/>
            <pc:sldMk cId="729325973" sldId="343"/>
            <ac:spMk id="8" creationId="{04A567A3-9E4C-F40B-6053-0D139EA8F2D3}"/>
          </ac:spMkLst>
        </pc:spChg>
        <pc:spChg chg="mod">
          <ac:chgData name="由美子 秋田" userId="982681295766d2be" providerId="LiveId" clId="{81DC723C-AF0E-4E57-9BD4-9DF701AD38B1}" dt="2024-12-03T06:44:49.740" v="229" actId="255"/>
          <ac:spMkLst>
            <pc:docMk/>
            <pc:sldMk cId="729325973" sldId="343"/>
            <ac:spMk id="10" creationId="{2F5FB0AB-0592-BD3C-2BA8-C4394A4F658B}"/>
          </ac:spMkLst>
        </pc:spChg>
      </pc:sldChg>
      <pc:sldChg chg="modSp mod">
        <pc:chgData name="由美子 秋田" userId="982681295766d2be" providerId="LiveId" clId="{81DC723C-AF0E-4E57-9BD4-9DF701AD38B1}" dt="2024-12-03T05:59:15.436" v="215" actId="2711"/>
        <pc:sldMkLst>
          <pc:docMk/>
          <pc:sldMk cId="1318259939" sldId="346"/>
        </pc:sldMkLst>
        <pc:spChg chg="mod">
          <ac:chgData name="由美子 秋田" userId="982681295766d2be" providerId="LiveId" clId="{81DC723C-AF0E-4E57-9BD4-9DF701AD38B1}" dt="2024-12-03T05:47:40.174" v="149" actId="2711"/>
          <ac:spMkLst>
            <pc:docMk/>
            <pc:sldMk cId="1318259939" sldId="346"/>
            <ac:spMk id="5" creationId="{CDBC993A-E358-D2B0-E6B3-F0F8CB474A0F}"/>
          </ac:spMkLst>
        </pc:spChg>
        <pc:spChg chg="mod">
          <ac:chgData name="由美子 秋田" userId="982681295766d2be" providerId="LiveId" clId="{81DC723C-AF0E-4E57-9BD4-9DF701AD38B1}" dt="2024-12-03T05:59:06.241" v="213" actId="255"/>
          <ac:spMkLst>
            <pc:docMk/>
            <pc:sldMk cId="1318259939" sldId="346"/>
            <ac:spMk id="7" creationId="{3D418DE7-4EA1-0869-1386-943E0AEECE2A}"/>
          </ac:spMkLst>
        </pc:spChg>
        <pc:spChg chg="mod">
          <ac:chgData name="由美子 秋田" userId="982681295766d2be" providerId="LiveId" clId="{81DC723C-AF0E-4E57-9BD4-9DF701AD38B1}" dt="2024-12-03T05:59:15.436" v="215" actId="2711"/>
          <ac:spMkLst>
            <pc:docMk/>
            <pc:sldMk cId="1318259939" sldId="346"/>
            <ac:spMk id="8" creationId="{2B02BDD0-D866-5BC9-E3C1-F6C15F3A13DE}"/>
          </ac:spMkLst>
        </pc:spChg>
      </pc:sldChg>
      <pc:sldChg chg="modSp mod">
        <pc:chgData name="由美子 秋田" userId="982681295766d2be" providerId="LiveId" clId="{81DC723C-AF0E-4E57-9BD4-9DF701AD38B1}" dt="2024-12-03T06:00:00.700" v="222" actId="20577"/>
        <pc:sldMkLst>
          <pc:docMk/>
          <pc:sldMk cId="155270153" sldId="347"/>
        </pc:sldMkLst>
        <pc:spChg chg="mod">
          <ac:chgData name="由美子 秋田" userId="982681295766d2be" providerId="LiveId" clId="{81DC723C-AF0E-4E57-9BD4-9DF701AD38B1}" dt="2024-12-03T06:00:00.700" v="222" actId="20577"/>
          <ac:spMkLst>
            <pc:docMk/>
            <pc:sldMk cId="155270153" sldId="347"/>
            <ac:spMk id="3" creationId="{98B3F4B0-6D84-3C3C-0F2B-000E690DECFF}"/>
          </ac:spMkLst>
        </pc:spChg>
      </pc:sldChg>
      <pc:sldChg chg="modSp mod">
        <pc:chgData name="由美子 秋田" userId="982681295766d2be" providerId="LiveId" clId="{81DC723C-AF0E-4E57-9BD4-9DF701AD38B1}" dt="2024-12-03T05:59:46.433" v="221" actId="255"/>
        <pc:sldMkLst>
          <pc:docMk/>
          <pc:sldMk cId="3971416951" sldId="362"/>
        </pc:sldMkLst>
        <pc:spChg chg="mod">
          <ac:chgData name="由美子 秋田" userId="982681295766d2be" providerId="LiveId" clId="{81DC723C-AF0E-4E57-9BD4-9DF701AD38B1}" dt="2024-12-03T03:59:59.975" v="37" actId="113"/>
          <ac:spMkLst>
            <pc:docMk/>
            <pc:sldMk cId="3971416951" sldId="362"/>
            <ac:spMk id="3" creationId="{1CFD4F94-C555-D9FA-A7CF-1E9C10E096C4}"/>
          </ac:spMkLst>
        </pc:spChg>
        <pc:spChg chg="mod">
          <ac:chgData name="由美子 秋田" userId="982681295766d2be" providerId="LiveId" clId="{81DC723C-AF0E-4E57-9BD4-9DF701AD38B1}" dt="2024-12-03T05:47:31.600" v="147" actId="2711"/>
          <ac:spMkLst>
            <pc:docMk/>
            <pc:sldMk cId="3971416951" sldId="362"/>
            <ac:spMk id="4" creationId="{EB4E8D51-477F-54C9-736C-4DC40ADC6BDD}"/>
          </ac:spMkLst>
        </pc:spChg>
        <pc:spChg chg="mod">
          <ac:chgData name="由美子 秋田" userId="982681295766d2be" providerId="LiveId" clId="{81DC723C-AF0E-4E57-9BD4-9DF701AD38B1}" dt="2024-12-03T05:59:26.519" v="217" actId="255"/>
          <ac:spMkLst>
            <pc:docMk/>
            <pc:sldMk cId="3971416951" sldId="362"/>
            <ac:spMk id="16" creationId="{61A26841-4344-B8CE-75E6-3E922156CFE4}"/>
          </ac:spMkLst>
        </pc:spChg>
        <pc:spChg chg="mod">
          <ac:chgData name="由美子 秋田" userId="982681295766d2be" providerId="LiveId" clId="{81DC723C-AF0E-4E57-9BD4-9DF701AD38B1}" dt="2024-12-03T05:59:34.813" v="219" actId="255"/>
          <ac:spMkLst>
            <pc:docMk/>
            <pc:sldMk cId="3971416951" sldId="362"/>
            <ac:spMk id="17" creationId="{46AAB6C7-85FB-6CAF-44EF-A20F99D5F753}"/>
          </ac:spMkLst>
        </pc:spChg>
        <pc:spChg chg="mod">
          <ac:chgData name="由美子 秋田" userId="982681295766d2be" providerId="LiveId" clId="{81DC723C-AF0E-4E57-9BD4-9DF701AD38B1}" dt="2024-12-03T05:59:46.433" v="221" actId="255"/>
          <ac:spMkLst>
            <pc:docMk/>
            <pc:sldMk cId="3971416951" sldId="362"/>
            <ac:spMk id="18" creationId="{1A42EBCD-631A-221A-A880-42A83AD02B1A}"/>
          </ac:spMkLst>
        </pc:spChg>
      </pc:sldChg>
      <pc:sldChg chg="modSp mod">
        <pc:chgData name="由美子 秋田" userId="982681295766d2be" providerId="LiveId" clId="{81DC723C-AF0E-4E57-9BD4-9DF701AD38B1}" dt="2024-12-03T05:57:31.084" v="198" actId="27636"/>
        <pc:sldMkLst>
          <pc:docMk/>
          <pc:sldMk cId="3442016219" sldId="363"/>
        </pc:sldMkLst>
        <pc:spChg chg="mod">
          <ac:chgData name="由美子 秋田" userId="982681295766d2be" providerId="LiveId" clId="{81DC723C-AF0E-4E57-9BD4-9DF701AD38B1}" dt="2024-12-03T05:57:31.084" v="198" actId="27636"/>
          <ac:spMkLst>
            <pc:docMk/>
            <pc:sldMk cId="3442016219" sldId="363"/>
            <ac:spMk id="2" creationId="{EF4BAD14-9D23-DD93-E98E-A27967EB58CB}"/>
          </ac:spMkLst>
        </pc:spChg>
        <pc:spChg chg="mod">
          <ac:chgData name="由美子 秋田" userId="982681295766d2be" providerId="LiveId" clId="{81DC723C-AF0E-4E57-9BD4-9DF701AD38B1}" dt="2024-12-03T04:13:01.864" v="73" actId="20577"/>
          <ac:spMkLst>
            <pc:docMk/>
            <pc:sldMk cId="3442016219" sldId="363"/>
            <ac:spMk id="9" creationId="{ED67790F-2FF6-7FE2-A2AA-6ED20E903C96}"/>
          </ac:spMkLst>
        </pc:spChg>
        <pc:spChg chg="mod">
          <ac:chgData name="由美子 秋田" userId="982681295766d2be" providerId="LiveId" clId="{81DC723C-AF0E-4E57-9BD4-9DF701AD38B1}" dt="2024-12-03T05:50:58.208" v="160" actId="2711"/>
          <ac:spMkLst>
            <pc:docMk/>
            <pc:sldMk cId="3442016219" sldId="363"/>
            <ac:spMk id="10" creationId="{FF1D98D5-98CD-95A0-A425-0EEA9C8113A3}"/>
          </ac:spMkLst>
        </pc:spChg>
      </pc:sldChg>
      <pc:sldChg chg="modSp mod">
        <pc:chgData name="由美子 秋田" userId="982681295766d2be" providerId="LiveId" clId="{81DC723C-AF0E-4E57-9BD4-9DF701AD38B1}" dt="2024-12-03T05:54:31.332" v="176" actId="2711"/>
        <pc:sldMkLst>
          <pc:docMk/>
          <pc:sldMk cId="650900424" sldId="365"/>
        </pc:sldMkLst>
        <pc:spChg chg="mod">
          <ac:chgData name="由美子 秋田" userId="982681295766d2be" providerId="LiveId" clId="{81DC723C-AF0E-4E57-9BD4-9DF701AD38B1}" dt="2024-12-03T04:12:35.859" v="66" actId="113"/>
          <ac:spMkLst>
            <pc:docMk/>
            <pc:sldMk cId="650900424" sldId="365"/>
            <ac:spMk id="3" creationId="{BE62216A-576E-EDC0-B212-203BA38EEA5A}"/>
          </ac:spMkLst>
        </pc:spChg>
        <pc:spChg chg="mod">
          <ac:chgData name="由美子 秋田" userId="982681295766d2be" providerId="LiveId" clId="{81DC723C-AF0E-4E57-9BD4-9DF701AD38B1}" dt="2024-12-03T05:52:05.982" v="170" actId="14100"/>
          <ac:spMkLst>
            <pc:docMk/>
            <pc:sldMk cId="650900424" sldId="365"/>
            <ac:spMk id="8" creationId="{DFB56669-5456-3556-57F6-F875DD06646D}"/>
          </ac:spMkLst>
        </pc:spChg>
        <pc:spChg chg="mod">
          <ac:chgData name="由美子 秋田" userId="982681295766d2be" providerId="LiveId" clId="{81DC723C-AF0E-4E57-9BD4-9DF701AD38B1}" dt="2024-12-03T05:54:23.187" v="174" actId="255"/>
          <ac:spMkLst>
            <pc:docMk/>
            <pc:sldMk cId="650900424" sldId="365"/>
            <ac:spMk id="9" creationId="{48563022-FAF0-794B-9439-BDFE1B4FA51E}"/>
          </ac:spMkLst>
        </pc:spChg>
        <pc:spChg chg="mod">
          <ac:chgData name="由美子 秋田" userId="982681295766d2be" providerId="LiveId" clId="{81DC723C-AF0E-4E57-9BD4-9DF701AD38B1}" dt="2024-12-03T05:54:31.332" v="176" actId="2711"/>
          <ac:spMkLst>
            <pc:docMk/>
            <pc:sldMk cId="650900424" sldId="365"/>
            <ac:spMk id="10" creationId="{76478FF0-EC42-6E3F-1956-0DAD0332BFEF}"/>
          </ac:spMkLst>
        </pc:spChg>
      </pc:sldChg>
      <pc:sldChg chg="modSp mod">
        <pc:chgData name="由美子 秋田" userId="982681295766d2be" providerId="LiveId" clId="{81DC723C-AF0E-4E57-9BD4-9DF701AD38B1}" dt="2024-12-03T06:42:45.636" v="225" actId="2711"/>
        <pc:sldMkLst>
          <pc:docMk/>
          <pc:sldMk cId="2378794941" sldId="367"/>
        </pc:sldMkLst>
        <pc:spChg chg="mod">
          <ac:chgData name="由美子 秋田" userId="982681295766d2be" providerId="LiveId" clId="{81DC723C-AF0E-4E57-9BD4-9DF701AD38B1}" dt="2024-12-03T06:42:45.636" v="225" actId="2711"/>
          <ac:spMkLst>
            <pc:docMk/>
            <pc:sldMk cId="2378794941" sldId="367"/>
            <ac:spMk id="6" creationId="{D21C2B75-DC2D-6E9F-EE5A-69089BEAD909}"/>
          </ac:spMkLst>
        </pc:spChg>
        <pc:spChg chg="mod">
          <ac:chgData name="由美子 秋田" userId="982681295766d2be" providerId="LiveId" clId="{81DC723C-AF0E-4E57-9BD4-9DF701AD38B1}" dt="2024-12-03T05:50:49.822" v="159" actId="2711"/>
          <ac:spMkLst>
            <pc:docMk/>
            <pc:sldMk cId="2378794941" sldId="367"/>
            <ac:spMk id="8" creationId="{385F37CE-6C6F-B614-5C27-276EFB47AB49}"/>
          </ac:spMkLst>
        </pc:spChg>
      </pc:sldChg>
      <pc:sldChg chg="modSp mod">
        <pc:chgData name="由美子 秋田" userId="982681295766d2be" providerId="LiveId" clId="{81DC723C-AF0E-4E57-9BD4-9DF701AD38B1}" dt="2024-12-03T05:47:22.001" v="145" actId="2711"/>
        <pc:sldMkLst>
          <pc:docMk/>
          <pc:sldMk cId="1066298654" sldId="368"/>
        </pc:sldMkLst>
        <pc:spChg chg="mod">
          <ac:chgData name="由美子 秋田" userId="982681295766d2be" providerId="LiveId" clId="{81DC723C-AF0E-4E57-9BD4-9DF701AD38B1}" dt="2024-12-03T05:47:22.001" v="145" actId="2711"/>
          <ac:spMkLst>
            <pc:docMk/>
            <pc:sldMk cId="1066298654" sldId="368"/>
            <ac:spMk id="4" creationId="{89A0FF72-456E-69A8-085B-E683612AEE14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20B3AD-354D-0447-9B80-889DEDB344F4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E47D25-8304-FC41-8203-0D9CBD2209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1846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4E47D25-8304-FC41-8203-0D9CBD22096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0196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795E973-B4E4-7341-BC67-4969F883D799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2116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606FE9E-1E47-194A-0E02-C86B00AD7B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E5223F79-81BD-0296-E582-5E394FC0CF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0DBBF6A-24A7-7124-4E42-AC7A02ABAB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7FF31-62C2-BC4C-9ADC-A9605AC174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64054FE-54E9-17D8-0E92-55C0A0EFCC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FFB15B1-337F-FFA7-8F03-E58C62C58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C19D-0886-DD42-94CC-295C69428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9818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C46F901-1FB5-88F4-5300-C4AA3F0C17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7929A7C9-218B-3D62-99DA-3065201F8C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CC791A8-6456-FFDF-E594-A7B9BDF39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7FF31-62C2-BC4C-9ADC-A9605AC174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7803AA2-52DA-19BB-E8BB-7EADD6A821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30FB9C5-DED9-2D96-6658-26D9B3CDAC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C19D-0886-DD42-94CC-295C69428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099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11ED821E-3041-2520-8BAC-F2D303178D5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9720BAE6-F28D-0A25-C41E-E76CB2F0E4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AE91810-E695-381A-E4F5-6EB052AE2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7FF31-62C2-BC4C-9ADC-A9605AC174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FDD3402-DE0A-DAC6-D60B-231F2AA04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0730015-FD29-63DD-75AE-1B61216E4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C19D-0886-DD42-94CC-295C69428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1993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DA46F50-BA5A-96CE-E29F-81A1E40279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2CE2614-8D67-41BC-2B87-F012EA3DC39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F5133BB-A6E0-84F1-D315-F2BD18AA4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7FF31-62C2-BC4C-9ADC-A9605AC174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1CEF42B-6325-6F44-E967-C448DB80E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ED9972B-2244-438E-0199-2B0AFE3119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C19D-0886-DD42-94CC-295C69428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4273345-F635-D873-8ECC-6489F7AB96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169C01A-4600-F687-572C-1C75C3633A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13DFCEF-4084-B5E9-D4E5-ACCEB3812F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7FF31-62C2-BC4C-9ADC-A9605AC174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DDC8E81-1C4E-B9B9-17A2-89BB08849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3C37453-E439-6145-0C5F-7E36C80694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C19D-0886-DD42-94CC-295C69428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343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1C7E7E3-9537-978A-1A0A-9D0F061034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BAD2607-469F-515B-E0A0-AEC92E77AA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A5E9975-B7B6-3CA7-E1EE-2C8949A273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F0323A7-15FD-5941-F379-C63DC8F15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7FF31-62C2-BC4C-9ADC-A9605AC174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23C5317D-62D8-1ABE-CB7D-3108B90A6F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0AD193E-386D-4A8C-681C-71BD501726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C19D-0886-DD42-94CC-295C69428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300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415D6A6-472A-29DF-AE76-39FE8A31AA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FFC3F5A-6A33-56D7-5230-E9853448A1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843F7011-158A-C259-E349-A04A3D157E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852B3C74-AE83-DC3D-AF8D-26EEEA80D6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34C56875-D7A8-C28B-F4A4-67A5EDEA41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C60BA84B-18C6-C709-7B21-AC464A113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7FF31-62C2-BC4C-9ADC-A9605AC174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6B74EC00-67AD-50F0-D2B6-4CB89F4039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C8644CEB-30B4-9A9F-B5AC-ADD465522B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C19D-0886-DD42-94CC-295C69428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2923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9A20C4D-D96F-A0F8-C0CE-F1AD316405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40D110EC-B1EE-DD4C-484C-5EB94EFFA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7FF31-62C2-BC4C-9ADC-A9605AC174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3FBE3D44-3691-C6C3-C878-DC27F3AC15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49A01B86-CC3B-11FF-4A5A-133279C45C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C19D-0886-DD42-94CC-295C69428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440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D60DF4A7-CCD6-2CBE-19EC-68F172DFFD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7FF31-62C2-BC4C-9ADC-A9605AC174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F197E5D4-6343-F232-5885-1B03A3EAC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CCF52EFE-9178-5D54-96B0-E2D369FFB8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C19D-0886-DD42-94CC-295C69428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0768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3C06325-15B8-FA43-3226-AE6544B22A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E2B77DBA-AFC4-0B77-99F5-A8574F1B0D2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308197F-B302-3088-7FBE-345DD15902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FECEBA9-3D74-0F27-8BE5-655C9CE7DF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7FF31-62C2-BC4C-9ADC-A9605AC174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99135AF-9B36-CD6E-42A3-CCC9FFB173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FA726E3-9219-ECD3-0134-3C319AAE3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C19D-0886-DD42-94CC-295C69428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538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DAB7622-56DA-09A2-355D-87D0DB507F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6F39B500-7859-D76A-16D7-E448C889A96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D6067D84-D097-5E16-8D7A-5B9CB2AAFC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1134776-2217-A970-960E-948CA4273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B7FF31-62C2-BC4C-9ADC-A9605AC174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87A0DFC-D327-6776-F927-299D5D98D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B9DCBD8-04FE-EDCB-1B3C-1D9A0AFC75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0CC19D-0886-DD42-94CC-295C69428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555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A8930B3E-CFDD-8D13-2A8D-889FD9B085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B0032E9-C735-531F-39E8-FE7B5E24E7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DDD5142-1324-8961-DF4F-CB295A4223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9B7FF31-62C2-BC4C-9ADC-A9605AC17406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C1F7057-8886-CFAB-9C4A-19510EB4A2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89EA969-2F94-EF99-6D0D-08EACDF194E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20CC19D-0886-DD42-94CC-295C694288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4018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xmlns="" id="{E1C57E3E-2C35-950F-91BE-EC3870EAC5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12011" y="133643"/>
            <a:ext cx="6193809" cy="5471012"/>
          </a:xfrm>
          <a:prstGeom prst="rect">
            <a:avLst/>
          </a:prstGeom>
        </p:spPr>
      </p:pic>
      <p:sp>
        <p:nvSpPr>
          <p:cNvPr id="4" name="タイトル 8">
            <a:extLst>
              <a:ext uri="{FF2B5EF4-FFF2-40B4-BE49-F238E27FC236}">
                <a16:creationId xmlns:a16="http://schemas.microsoft.com/office/drawing/2014/main" xmlns="" id="{B7E120EC-CACF-CF6A-CCDA-2FA84B475F6E}"/>
              </a:ext>
            </a:extLst>
          </p:cNvPr>
          <p:cNvSpPr txBox="1">
            <a:spLocks/>
          </p:cNvSpPr>
          <p:nvPr/>
        </p:nvSpPr>
        <p:spPr>
          <a:xfrm>
            <a:off x="77816" y="26996"/>
            <a:ext cx="3906328" cy="46065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imental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xmlns="" id="{E14517FC-5D09-F4D7-BD30-60E0209BDD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023" y="5953760"/>
            <a:ext cx="7977613" cy="551543"/>
          </a:xfrm>
        </p:spPr>
        <p:txBody>
          <a:bodyPr>
            <a:norm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 Fig1</a:t>
            </a:r>
            <a:r>
              <a:rPr lang="ja-JP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We further analyzed high and low expression regions within Island tumors to explore intra-tumor heterogeneity. Although differential gene expression analysis identified significantly differentially expressed genes (FDR q-value &lt; 0.05, n = 2),we were unable to establish a functional role for intra-tumor heterogeneity.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85742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8">
            <a:extLst>
              <a:ext uri="{FF2B5EF4-FFF2-40B4-BE49-F238E27FC236}">
                <a16:creationId xmlns:a16="http://schemas.microsoft.com/office/drawing/2014/main" xmlns="" id="{89A0FF72-456E-69A8-085B-E683612AEE14}"/>
              </a:ext>
            </a:extLst>
          </p:cNvPr>
          <p:cNvSpPr txBox="1">
            <a:spLocks/>
          </p:cNvSpPr>
          <p:nvPr/>
        </p:nvSpPr>
        <p:spPr>
          <a:xfrm>
            <a:off x="77816" y="26996"/>
            <a:ext cx="3906328" cy="46065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imental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xmlns="" id="{CFAA80B5-80BE-E5F5-3D24-D3DF662082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0239" y="1886562"/>
            <a:ext cx="3895682" cy="3450635"/>
          </a:xfrm>
          <a:prstGeom prst="rect">
            <a:avLst/>
          </a:prstGeom>
        </p:spPr>
      </p:pic>
      <p:pic>
        <p:nvPicPr>
          <p:cNvPr id="6" name="Picture 9" descr="A diagram of a number&#10;&#10;Description automatically generated">
            <a:extLst>
              <a:ext uri="{FF2B5EF4-FFF2-40B4-BE49-F238E27FC236}">
                <a16:creationId xmlns:a16="http://schemas.microsoft.com/office/drawing/2014/main" xmlns="" id="{64B48AD7-26DA-E229-CB9A-D12B68E6F05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56081" y="1679609"/>
            <a:ext cx="3894667" cy="3498781"/>
          </a:xfrm>
          <a:prstGeom prst="rect">
            <a:avLst/>
          </a:prstGeom>
        </p:spPr>
      </p:pic>
      <p:sp>
        <p:nvSpPr>
          <p:cNvPr id="8" name="Title 1">
            <a:extLst>
              <a:ext uri="{FF2B5EF4-FFF2-40B4-BE49-F238E27FC236}">
                <a16:creationId xmlns:a16="http://schemas.microsoft.com/office/drawing/2014/main" xmlns="" id="{C19B9AD4-EA35-AE1E-6BC7-ED7FB28455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2616" y="5588000"/>
            <a:ext cx="7977613" cy="551543"/>
          </a:xfrm>
        </p:spPr>
        <p:txBody>
          <a:bodyPr>
            <a:normAutofit/>
          </a:bodyPr>
          <a:lstStyle/>
          <a:p>
            <a:r>
              <a:rPr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 Fig2</a:t>
            </a:r>
            <a:r>
              <a:rPr lang="ja-JP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verlapping candidates in Island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High E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Island Low ER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FDR 0.05 and fold change 1.5.</a:t>
            </a:r>
            <a:b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_int_High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sland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R-in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igh ER areas; </a:t>
            </a:r>
            <a:r>
              <a:rPr lang="en-US" altLang="ja-JP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_int_Low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sland ER-int Low ER areas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High: ER-high; Low: ER-low, T: TNBC</a:t>
            </a:r>
          </a:p>
        </p:txBody>
      </p:sp>
    </p:spTree>
    <p:extLst>
      <p:ext uri="{BB962C8B-B14F-4D97-AF65-F5344CB8AC3E}">
        <p14:creationId xmlns:p14="http://schemas.microsoft.com/office/powerpoint/2010/main" val="10662986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B24CC105-307F-425D-551F-249B0975E73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F8E0D62-881E-BDFE-7790-3DB67539FB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07522" y="6100470"/>
            <a:ext cx="7992094" cy="391194"/>
          </a:xfrm>
        </p:spPr>
        <p:txBody>
          <a:bodyPr>
            <a:normAutofit fontScale="90000"/>
          </a:bodyPr>
          <a:lstStyle/>
          <a:p>
            <a:r>
              <a:rPr lang="en-US" sz="1200" dirty="0"/>
              <a:t/>
            </a:r>
            <a:br>
              <a:rPr lang="en-US" sz="1200" dirty="0"/>
            </a:b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 fi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ja-JP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for Scatter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-int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en compared with other tumor types (n = 73).</a:t>
            </a:r>
            <a:b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: ER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; Low: ER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; T: TNBC;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_In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ater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R-int</a:t>
            </a:r>
            <a:r>
              <a:rPr lang="en-US" sz="1200" dirty="0"/>
              <a:t/>
            </a:r>
            <a:br>
              <a:rPr lang="en-US" sz="1200" dirty="0"/>
            </a:br>
            <a:endParaRPr lang="en-US" sz="1200" dirty="0"/>
          </a:p>
        </p:txBody>
      </p:sp>
      <p:pic>
        <p:nvPicPr>
          <p:cNvPr id="5" name="Picture 4" descr="A blue and red graph&#10;&#10;Description automatically generated">
            <a:extLst>
              <a:ext uri="{FF2B5EF4-FFF2-40B4-BE49-F238E27FC236}">
                <a16:creationId xmlns:a16="http://schemas.microsoft.com/office/drawing/2014/main" xmlns="" id="{3F31EC8E-176D-C8DA-3618-2273A1DE426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77865" y="415639"/>
            <a:ext cx="6516757" cy="5684831"/>
          </a:xfrm>
          <a:prstGeom prst="rect">
            <a:avLst/>
          </a:prstGeom>
        </p:spPr>
      </p:pic>
      <p:sp>
        <p:nvSpPr>
          <p:cNvPr id="3" name="タイトル 8">
            <a:extLst>
              <a:ext uri="{FF2B5EF4-FFF2-40B4-BE49-F238E27FC236}">
                <a16:creationId xmlns:a16="http://schemas.microsoft.com/office/drawing/2014/main" xmlns="" id="{98B3F4B0-6D84-3C3C-0F2B-000E690DECFF}"/>
              </a:ext>
            </a:extLst>
          </p:cNvPr>
          <p:cNvSpPr txBox="1">
            <a:spLocks/>
          </p:cNvSpPr>
          <p:nvPr/>
        </p:nvSpPr>
        <p:spPr>
          <a:xfrm>
            <a:off x="77816" y="26996"/>
            <a:ext cx="3906328" cy="46065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imental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igure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2701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543311A1-B9AD-AB67-1F03-AD418A606B4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graph with purple and blue bars&#10;&#10;Description automatically generated">
            <a:extLst>
              <a:ext uri="{FF2B5EF4-FFF2-40B4-BE49-F238E27FC236}">
                <a16:creationId xmlns:a16="http://schemas.microsoft.com/office/drawing/2014/main" xmlns="" id="{54C540A8-3C16-05F9-A122-13A7390219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7438" y="1150800"/>
            <a:ext cx="5465426" cy="4827629"/>
          </a:xfrm>
          <a:prstGeom prst="rect">
            <a:avLst/>
          </a:prstGeom>
        </p:spPr>
      </p:pic>
      <p:pic>
        <p:nvPicPr>
          <p:cNvPr id="4" name="Picture 3" descr="A screenshot of a graph&#10;&#10;Description automatically generated">
            <a:extLst>
              <a:ext uri="{FF2B5EF4-FFF2-40B4-BE49-F238E27FC236}">
                <a16:creationId xmlns:a16="http://schemas.microsoft.com/office/drawing/2014/main" xmlns="" id="{F660FE33-CDFB-4D20-BCEC-0D8C17C181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8486" y="1275392"/>
            <a:ext cx="5214999" cy="4549254"/>
          </a:xfrm>
          <a:prstGeom prst="rect">
            <a:avLst/>
          </a:prstGeom>
        </p:spPr>
      </p:pic>
      <p:sp>
        <p:nvSpPr>
          <p:cNvPr id="3" name="Title 1">
            <a:extLst>
              <a:ext uri="{FF2B5EF4-FFF2-40B4-BE49-F238E27FC236}">
                <a16:creationId xmlns:a16="http://schemas.microsoft.com/office/drawing/2014/main" xmlns="" id="{D817F767-4767-938D-5DB2-08D9AB816025}"/>
              </a:ext>
            </a:extLst>
          </p:cNvPr>
          <p:cNvSpPr txBox="1">
            <a:spLocks/>
          </p:cNvSpPr>
          <p:nvPr/>
        </p:nvSpPr>
        <p:spPr>
          <a:xfrm>
            <a:off x="415637" y="5876801"/>
            <a:ext cx="9455038" cy="77354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 fig.3 : 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tmap and gene expression of potentially interesting genes in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land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-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</a:t>
            </a:r>
            <a:r>
              <a:rPr lang="ja-JP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s compared to Scatter ER-int tumors.</a:t>
            </a:r>
          </a:p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atmap of the differentially expressed genes in Island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-int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s (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_int_entir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hen compared with scatter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-int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c-Int) tumors.</a:t>
            </a:r>
          </a:p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 pattern of the DEGs between Island and Scatter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-int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s.</a:t>
            </a:r>
          </a:p>
          <a:p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L_Int_Entire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Island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-in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_Int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Scatter 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R-int</a:t>
            </a:r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タイトル 8">
            <a:extLst>
              <a:ext uri="{FF2B5EF4-FFF2-40B4-BE49-F238E27FC236}">
                <a16:creationId xmlns:a16="http://schemas.microsoft.com/office/drawing/2014/main" xmlns="" id="{2E6A134F-4F5E-D8F3-606D-6C55C59949FA}"/>
              </a:ext>
            </a:extLst>
          </p:cNvPr>
          <p:cNvSpPr txBox="1">
            <a:spLocks/>
          </p:cNvSpPr>
          <p:nvPr/>
        </p:nvSpPr>
        <p:spPr>
          <a:xfrm>
            <a:off x="77816" y="26996"/>
            <a:ext cx="3906328" cy="46065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imental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igure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タイトル 8">
            <a:extLst>
              <a:ext uri="{FF2B5EF4-FFF2-40B4-BE49-F238E27FC236}">
                <a16:creationId xmlns:a16="http://schemas.microsoft.com/office/drawing/2014/main" xmlns="" id="{04A567A3-9E4C-F40B-6053-0D139EA8F2D3}"/>
              </a:ext>
            </a:extLst>
          </p:cNvPr>
          <p:cNvSpPr txBox="1">
            <a:spLocks/>
          </p:cNvSpPr>
          <p:nvPr/>
        </p:nvSpPr>
        <p:spPr>
          <a:xfrm>
            <a:off x="415637" y="975965"/>
            <a:ext cx="459219" cy="24727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タイトル 8">
            <a:extLst>
              <a:ext uri="{FF2B5EF4-FFF2-40B4-BE49-F238E27FC236}">
                <a16:creationId xmlns:a16="http://schemas.microsoft.com/office/drawing/2014/main" xmlns="" id="{2F5FB0AB-0592-BD3C-2BA8-C4394A4F658B}"/>
              </a:ext>
            </a:extLst>
          </p:cNvPr>
          <p:cNvSpPr txBox="1">
            <a:spLocks/>
          </p:cNvSpPr>
          <p:nvPr/>
        </p:nvSpPr>
        <p:spPr>
          <a:xfrm>
            <a:off x="6364621" y="975965"/>
            <a:ext cx="459219" cy="24727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729325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61</TotalTime>
  <Words>163</Words>
  <Application>Microsoft Office PowerPoint</Application>
  <PresentationFormat>Widescreen</PresentationFormat>
  <Paragraphs>15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2" baseType="lpstr">
      <vt:lpstr>游ゴシック</vt:lpstr>
      <vt:lpstr>游ゴシック Light</vt:lpstr>
      <vt:lpstr>Aptos</vt:lpstr>
      <vt:lpstr>Aptos Display</vt:lpstr>
      <vt:lpstr>Arial</vt:lpstr>
      <vt:lpstr>Times New Roman</vt:lpstr>
      <vt:lpstr>游明朝</vt:lpstr>
      <vt:lpstr>Office Theme</vt:lpstr>
      <vt:lpstr>Supp Fig1 :We further analyzed high and low expression regions within Island tumors to explore intra-tumor heterogeneity. Although differential gene expression analysis identified significantly differentially expressed genes (FDR q-value &lt; 0.05, n = 2),we were unable to establish a functional role for intra-tumor heterogeneity.</vt:lpstr>
      <vt:lpstr>Supp Fig2 : Overlapping candidates in Island  High ER and in Island Low ER  with FDR 0.05 and fold change 1.5. IL_int_High: Island ER-int High ER areas; IL_int_Low: Island ER-int Low ER areas; High: ER-high; Low: ER-low, T: TNBC</vt:lpstr>
      <vt:lpstr> Suppl fig 3: Heatmap for Scatter ER-int tumor when compared with other tumor types (n = 73). High: ER-high; Low: ER-low; T: TNBC; Sc_Int: Scater ER-int 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 Fig1 :We further analyzed high and low expression regions within Island tumors to explore intra-tumor heterogeneity. Although differential gene expression analysis identified significantly differentially expressed genes (FDR q-value &lt; 0.05, n = 2),we were unable to establish a functional role for intra-tumor heterogeneity.</dc:title>
  <dc:creator>VELAGA Ravindranath Maruthi</dc:creator>
  <cp:lastModifiedBy>Raja R Ramasamy M</cp:lastModifiedBy>
  <cp:revision>8</cp:revision>
  <dcterms:created xsi:type="dcterms:W3CDTF">2024-11-04T00:57:28Z</dcterms:created>
  <dcterms:modified xsi:type="dcterms:W3CDTF">2025-05-06T01:52:49Z</dcterms:modified>
</cp:coreProperties>
</file>